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D5A746-EB72-4DDF-BAD8-B45F428D4F4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F8CA39-4A39-4512-982B-E66DD943EB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46CA2B-AF65-4158-A8B1-671FA2A852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39272B-11B7-4FE0-A765-C9EEC06191B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E01767-DC01-4748-9D1C-4EF0709419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2FE937-FE1E-4727-8F47-C21ABD3630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9062FF-E7D7-41C5-9B06-C8F38D6B5D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B8281F-751A-4B90-B3ED-EDE29E6652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90B110-A83C-4C7E-BB93-0182B2F072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443B16-B361-428A-8940-811CF74C81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E4BE37-767C-42FA-B0C9-B9EE8082CE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52AF57-F8AE-44CF-8464-451D9A3232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4A6FFE-433A-4795-B4A3-D2D1D51602D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4940280" y="1830240"/>
            <a:ext cx="3719520" cy="3905280"/>
            <a:chOff x="4940280" y="1830240"/>
            <a:chExt cx="3719520" cy="3905280"/>
          </a:xfrm>
        </p:grpSpPr>
        <p:sp>
          <p:nvSpPr>
            <p:cNvPr id="42" name=""/>
            <p:cNvSpPr/>
            <p:nvPr/>
          </p:nvSpPr>
          <p:spPr>
            <a:xfrm>
              <a:off x="6838920" y="5154480"/>
              <a:ext cx="1820880" cy="581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spcBef>
                  <a:spcPts val="4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59.2 / 57.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4940280" y="5154480"/>
              <a:ext cx="1898640" cy="581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spcBef>
                  <a:spcPts val="4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</a:rPr>
                <a:t>% Sensitivity / Specificit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6838920" y="4573440"/>
              <a:ext cx="1820880" cy="581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spcBef>
                  <a:spcPts val="4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0.059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4940280" y="4573440"/>
              <a:ext cx="1898640" cy="581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spcBef>
                  <a:spcPts val="4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</a:rPr>
                <a:t>Significance level P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6838920" y="3992400"/>
              <a:ext cx="1820880" cy="581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spcBef>
                  <a:spcPts val="4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0.52 - 0.59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940280" y="3992400"/>
              <a:ext cx="1898640" cy="581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spcBef>
                  <a:spcPts val="4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95% CI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6838920" y="3411360"/>
              <a:ext cx="1820880" cy="581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spcBef>
                  <a:spcPts val="4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0.0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940280" y="3411360"/>
              <a:ext cx="1898640" cy="581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spcBef>
                  <a:spcPts val="4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</a:rPr>
                <a:t>Standard erro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6838920" y="2830320"/>
              <a:ext cx="1820880" cy="581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spcBef>
                  <a:spcPts val="4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0.56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940280" y="2830320"/>
              <a:ext cx="1898640" cy="581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spcBef>
                  <a:spcPts val="4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</a:rPr>
                <a:t>AUC valu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6838920" y="2199960"/>
              <a:ext cx="1820880" cy="630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spcBef>
                  <a:spcPts val="4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98 / 598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940280" y="2199960"/>
              <a:ext cx="1898640" cy="630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spcBef>
                  <a:spcPts val="4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</a:rPr>
                <a:t>Sample siz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4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</a:rPr>
                <a:t>case/control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6838920" y="1830240"/>
              <a:ext cx="1820880" cy="36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spcBef>
                  <a:spcPts val="4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cGvHD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940280" y="1830240"/>
              <a:ext cx="1898640" cy="36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spcBef>
                  <a:spcPts val="4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</a:rPr>
                <a:t>Patient group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4940280" y="1830240"/>
              <a:ext cx="3719520" cy="0"/>
            </a:xfrm>
            <a:prstGeom prst="line">
              <a:avLst/>
            </a:prstGeom>
            <a:ln cap="sq"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940280" y="2199960"/>
              <a:ext cx="3719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4940280" y="2830320"/>
              <a:ext cx="3719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940280" y="3411360"/>
              <a:ext cx="3719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4940280" y="3992400"/>
              <a:ext cx="3719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940280" y="4573440"/>
              <a:ext cx="3719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940280" y="5154480"/>
              <a:ext cx="3719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4940280" y="5735520"/>
              <a:ext cx="3719520" cy="0"/>
            </a:xfrm>
            <a:prstGeom prst="line">
              <a:avLst/>
            </a:prstGeom>
            <a:ln cap="sq"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4940280" y="1830240"/>
              <a:ext cx="0" cy="3905280"/>
            </a:xfrm>
            <a:prstGeom prst="line">
              <a:avLst/>
            </a:prstGeom>
            <a:ln cap="sq"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6838920" y="1830240"/>
              <a:ext cx="0" cy="3905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8659800" y="1830240"/>
              <a:ext cx="0" cy="3905280"/>
            </a:xfrm>
            <a:prstGeom prst="line">
              <a:avLst/>
            </a:prstGeom>
            <a:ln cap="sq"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7" name=""/>
          <p:cNvSpPr/>
          <p:nvPr/>
        </p:nvSpPr>
        <p:spPr>
          <a:xfrm>
            <a:off x="327600" y="18900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8" name=""/>
          <p:cNvGrpSpPr/>
          <p:nvPr/>
        </p:nvGrpSpPr>
        <p:grpSpPr>
          <a:xfrm>
            <a:off x="463680" y="1978200"/>
            <a:ext cx="4008240" cy="3872520"/>
            <a:chOff x="463680" y="1978200"/>
            <a:chExt cx="4008240" cy="3872520"/>
          </a:xfrm>
        </p:grpSpPr>
        <p:sp>
          <p:nvSpPr>
            <p:cNvPr id="69" name=""/>
            <p:cNvSpPr/>
            <p:nvPr/>
          </p:nvSpPr>
          <p:spPr>
            <a:xfrm>
              <a:off x="1071720" y="1996920"/>
              <a:ext cx="3346200" cy="3337200"/>
            </a:xfrm>
            <a:prstGeom prst="rect">
              <a:avLst/>
            </a:prstGeom>
            <a:noFill/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flipV="1">
              <a:off x="1157400" y="5254200"/>
              <a:ext cx="0" cy="73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flipV="1">
              <a:off x="1317600" y="5290920"/>
              <a:ext cx="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 flipV="1">
              <a:off x="1477800" y="5290920"/>
              <a:ext cx="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 flipV="1">
              <a:off x="1631880" y="5290920"/>
              <a:ext cx="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flipV="1">
              <a:off x="1792440" y="5254200"/>
              <a:ext cx="0" cy="73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 flipV="1">
              <a:off x="1952640" y="5290920"/>
              <a:ext cx="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 flipV="1">
              <a:off x="2112840" y="5290920"/>
              <a:ext cx="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flipV="1">
              <a:off x="2266920" y="5290920"/>
              <a:ext cx="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flipV="1">
              <a:off x="2427120" y="5254200"/>
              <a:ext cx="0" cy="73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flipV="1">
              <a:off x="2587680" y="5290920"/>
              <a:ext cx="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flipV="1">
              <a:off x="2747880" y="5290920"/>
              <a:ext cx="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flipV="1">
              <a:off x="2901960" y="5290920"/>
              <a:ext cx="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flipV="1">
              <a:off x="3062160" y="5254200"/>
              <a:ext cx="0" cy="73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V="1">
              <a:off x="3222720" y="5290920"/>
              <a:ext cx="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flipV="1">
              <a:off x="3382920" y="5290920"/>
              <a:ext cx="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flipV="1">
              <a:off x="3537000" y="5290920"/>
              <a:ext cx="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flipV="1">
              <a:off x="3697200" y="5254200"/>
              <a:ext cx="0" cy="73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flipV="1">
              <a:off x="3857760" y="5290920"/>
              <a:ext cx="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flipV="1">
              <a:off x="4017960" y="5290920"/>
              <a:ext cx="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flipV="1">
              <a:off x="4173480" y="5290920"/>
              <a:ext cx="0" cy="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flipV="1">
              <a:off x="4332240" y="5254200"/>
              <a:ext cx="0" cy="73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076400" y="2082960"/>
              <a:ext cx="74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076400" y="2716200"/>
              <a:ext cx="74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076400" y="2557440"/>
              <a:ext cx="38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076400" y="2397240"/>
              <a:ext cx="38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1076400" y="2243160"/>
              <a:ext cx="38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1076400" y="3349800"/>
              <a:ext cx="74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1076400" y="3189240"/>
              <a:ext cx="38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1076400" y="3030480"/>
              <a:ext cx="38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1076400" y="2874960"/>
              <a:ext cx="38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1076400" y="3981600"/>
              <a:ext cx="74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1076400" y="3822840"/>
              <a:ext cx="38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1076400" y="3662280"/>
              <a:ext cx="38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1076400" y="3508200"/>
              <a:ext cx="38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1076400" y="4614840"/>
              <a:ext cx="74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1076400" y="4456080"/>
              <a:ext cx="38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1076400" y="4295880"/>
              <a:ext cx="38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1076400" y="4141800"/>
              <a:ext cx="38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1076400" y="5248440"/>
              <a:ext cx="74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1076400" y="5087880"/>
              <a:ext cx="38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1076400" y="4929120"/>
              <a:ext cx="38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1076400" y="4773600"/>
              <a:ext cx="38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 flipV="1">
              <a:off x="1157400" y="2082600"/>
              <a:ext cx="3174840" cy="3165480"/>
            </a:xfrm>
            <a:prstGeom prst="line">
              <a:avLst/>
            </a:prstGeom>
            <a:ln w="64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1157400" y="2082960"/>
              <a:ext cx="3174840" cy="3165480"/>
            </a:xfrm>
            <a:custGeom>
              <a:avLst/>
              <a:gdLst/>
              <a:ahLst/>
              <a:rect l="l" t="t" r="r" b="b"/>
              <a:pathLst>
                <a:path w="1943" h="1945">
                  <a:moveTo>
                    <a:pt x="0" y="1945"/>
                  </a:moveTo>
                  <a:lnTo>
                    <a:pt x="4" y="1945"/>
                  </a:lnTo>
                  <a:lnTo>
                    <a:pt x="8" y="1926"/>
                  </a:lnTo>
                  <a:lnTo>
                    <a:pt x="12" y="1926"/>
                  </a:lnTo>
                  <a:lnTo>
                    <a:pt x="12" y="1908"/>
                  </a:lnTo>
                  <a:lnTo>
                    <a:pt x="16" y="1908"/>
                  </a:lnTo>
                  <a:lnTo>
                    <a:pt x="19" y="1908"/>
                  </a:lnTo>
                  <a:lnTo>
                    <a:pt x="23" y="1908"/>
                  </a:lnTo>
                  <a:lnTo>
                    <a:pt x="27" y="1908"/>
                  </a:lnTo>
                  <a:lnTo>
                    <a:pt x="31" y="1908"/>
                  </a:lnTo>
                  <a:lnTo>
                    <a:pt x="34" y="1889"/>
                  </a:lnTo>
                  <a:lnTo>
                    <a:pt x="38" y="1889"/>
                  </a:lnTo>
                  <a:lnTo>
                    <a:pt x="42" y="1889"/>
                  </a:lnTo>
                  <a:lnTo>
                    <a:pt x="46" y="1889"/>
                  </a:lnTo>
                  <a:lnTo>
                    <a:pt x="49" y="1866"/>
                  </a:lnTo>
                  <a:lnTo>
                    <a:pt x="53" y="1866"/>
                  </a:lnTo>
                  <a:lnTo>
                    <a:pt x="53" y="1847"/>
                  </a:lnTo>
                  <a:lnTo>
                    <a:pt x="57" y="1828"/>
                  </a:lnTo>
                  <a:lnTo>
                    <a:pt x="61" y="1828"/>
                  </a:lnTo>
                  <a:lnTo>
                    <a:pt x="65" y="1828"/>
                  </a:lnTo>
                  <a:lnTo>
                    <a:pt x="68" y="1828"/>
                  </a:lnTo>
                  <a:lnTo>
                    <a:pt x="72" y="1828"/>
                  </a:lnTo>
                  <a:lnTo>
                    <a:pt x="76" y="1828"/>
                  </a:lnTo>
                  <a:lnTo>
                    <a:pt x="80" y="1828"/>
                  </a:lnTo>
                  <a:lnTo>
                    <a:pt x="83" y="1828"/>
                  </a:lnTo>
                  <a:lnTo>
                    <a:pt x="87" y="1809"/>
                  </a:lnTo>
                  <a:lnTo>
                    <a:pt x="91" y="1809"/>
                  </a:lnTo>
                  <a:lnTo>
                    <a:pt x="95" y="1809"/>
                  </a:lnTo>
                  <a:lnTo>
                    <a:pt x="99" y="1809"/>
                  </a:lnTo>
                  <a:lnTo>
                    <a:pt x="102" y="1809"/>
                  </a:lnTo>
                  <a:lnTo>
                    <a:pt x="106" y="1809"/>
                  </a:lnTo>
                  <a:lnTo>
                    <a:pt x="110" y="1809"/>
                  </a:lnTo>
                  <a:lnTo>
                    <a:pt x="114" y="1809"/>
                  </a:lnTo>
                  <a:lnTo>
                    <a:pt x="117" y="1809"/>
                  </a:lnTo>
                  <a:lnTo>
                    <a:pt x="121" y="1809"/>
                  </a:lnTo>
                  <a:lnTo>
                    <a:pt x="121" y="1787"/>
                  </a:lnTo>
                  <a:lnTo>
                    <a:pt x="125" y="1787"/>
                  </a:lnTo>
                  <a:lnTo>
                    <a:pt x="125" y="1768"/>
                  </a:lnTo>
                  <a:lnTo>
                    <a:pt x="125" y="1749"/>
                  </a:lnTo>
                  <a:lnTo>
                    <a:pt x="129" y="1749"/>
                  </a:lnTo>
                  <a:lnTo>
                    <a:pt x="129" y="1730"/>
                  </a:lnTo>
                  <a:lnTo>
                    <a:pt x="132" y="1730"/>
                  </a:lnTo>
                  <a:lnTo>
                    <a:pt x="136" y="1730"/>
                  </a:lnTo>
                  <a:lnTo>
                    <a:pt x="140" y="1730"/>
                  </a:lnTo>
                  <a:lnTo>
                    <a:pt x="144" y="1730"/>
                  </a:lnTo>
                  <a:lnTo>
                    <a:pt x="148" y="1730"/>
                  </a:lnTo>
                  <a:lnTo>
                    <a:pt x="151" y="1730"/>
                  </a:lnTo>
                  <a:lnTo>
                    <a:pt x="155" y="1730"/>
                  </a:lnTo>
                  <a:lnTo>
                    <a:pt x="159" y="1730"/>
                  </a:lnTo>
                  <a:lnTo>
                    <a:pt x="163" y="1730"/>
                  </a:lnTo>
                  <a:lnTo>
                    <a:pt x="163" y="1707"/>
                  </a:lnTo>
                  <a:lnTo>
                    <a:pt x="166" y="1707"/>
                  </a:lnTo>
                  <a:lnTo>
                    <a:pt x="170" y="1707"/>
                  </a:lnTo>
                  <a:lnTo>
                    <a:pt x="174" y="1707"/>
                  </a:lnTo>
                  <a:lnTo>
                    <a:pt x="174" y="1688"/>
                  </a:lnTo>
                  <a:lnTo>
                    <a:pt x="178" y="1688"/>
                  </a:lnTo>
                  <a:lnTo>
                    <a:pt x="178" y="1670"/>
                  </a:lnTo>
                  <a:lnTo>
                    <a:pt x="181" y="1670"/>
                  </a:lnTo>
                  <a:lnTo>
                    <a:pt x="185" y="1670"/>
                  </a:lnTo>
                  <a:lnTo>
                    <a:pt x="189" y="1670"/>
                  </a:lnTo>
                  <a:lnTo>
                    <a:pt x="197" y="1670"/>
                  </a:lnTo>
                  <a:lnTo>
                    <a:pt x="200" y="1670"/>
                  </a:lnTo>
                  <a:lnTo>
                    <a:pt x="204" y="1670"/>
                  </a:lnTo>
                  <a:lnTo>
                    <a:pt x="204" y="1651"/>
                  </a:lnTo>
                  <a:lnTo>
                    <a:pt x="208" y="1651"/>
                  </a:lnTo>
                  <a:lnTo>
                    <a:pt x="208" y="1628"/>
                  </a:lnTo>
                  <a:lnTo>
                    <a:pt x="208" y="1609"/>
                  </a:lnTo>
                  <a:lnTo>
                    <a:pt x="219" y="1609"/>
                  </a:lnTo>
                  <a:lnTo>
                    <a:pt x="223" y="1609"/>
                  </a:lnTo>
                  <a:lnTo>
                    <a:pt x="223" y="1590"/>
                  </a:lnTo>
                  <a:lnTo>
                    <a:pt x="227" y="1590"/>
                  </a:lnTo>
                  <a:lnTo>
                    <a:pt x="231" y="1590"/>
                  </a:lnTo>
                  <a:lnTo>
                    <a:pt x="234" y="1590"/>
                  </a:lnTo>
                  <a:lnTo>
                    <a:pt x="242" y="1590"/>
                  </a:lnTo>
                  <a:lnTo>
                    <a:pt x="246" y="1590"/>
                  </a:lnTo>
                  <a:lnTo>
                    <a:pt x="249" y="1590"/>
                  </a:lnTo>
                  <a:lnTo>
                    <a:pt x="253" y="1590"/>
                  </a:lnTo>
                  <a:lnTo>
                    <a:pt x="253" y="1571"/>
                  </a:lnTo>
                  <a:lnTo>
                    <a:pt x="257" y="1571"/>
                  </a:lnTo>
                  <a:lnTo>
                    <a:pt x="261" y="1571"/>
                  </a:lnTo>
                  <a:lnTo>
                    <a:pt x="264" y="1571"/>
                  </a:lnTo>
                  <a:lnTo>
                    <a:pt x="268" y="1571"/>
                  </a:lnTo>
                  <a:lnTo>
                    <a:pt x="272" y="1571"/>
                  </a:lnTo>
                  <a:lnTo>
                    <a:pt x="276" y="1571"/>
                  </a:lnTo>
                  <a:lnTo>
                    <a:pt x="280" y="1549"/>
                  </a:lnTo>
                  <a:lnTo>
                    <a:pt x="283" y="1530"/>
                  </a:lnTo>
                  <a:lnTo>
                    <a:pt x="287" y="1530"/>
                  </a:lnTo>
                  <a:lnTo>
                    <a:pt x="291" y="1530"/>
                  </a:lnTo>
                  <a:lnTo>
                    <a:pt x="295" y="1530"/>
                  </a:lnTo>
                  <a:lnTo>
                    <a:pt x="298" y="1530"/>
                  </a:lnTo>
                  <a:lnTo>
                    <a:pt x="302" y="1511"/>
                  </a:lnTo>
                  <a:lnTo>
                    <a:pt x="306" y="1511"/>
                  </a:lnTo>
                  <a:lnTo>
                    <a:pt x="310" y="1511"/>
                  </a:lnTo>
                  <a:lnTo>
                    <a:pt x="317" y="1511"/>
                  </a:lnTo>
                  <a:lnTo>
                    <a:pt x="325" y="1511"/>
                  </a:lnTo>
                  <a:lnTo>
                    <a:pt x="329" y="1511"/>
                  </a:lnTo>
                  <a:lnTo>
                    <a:pt x="332" y="1511"/>
                  </a:lnTo>
                  <a:lnTo>
                    <a:pt x="340" y="1511"/>
                  </a:lnTo>
                  <a:lnTo>
                    <a:pt x="344" y="1511"/>
                  </a:lnTo>
                  <a:lnTo>
                    <a:pt x="344" y="1492"/>
                  </a:lnTo>
                  <a:lnTo>
                    <a:pt x="347" y="1492"/>
                  </a:lnTo>
                  <a:lnTo>
                    <a:pt x="347" y="1469"/>
                  </a:lnTo>
                  <a:lnTo>
                    <a:pt x="351" y="1469"/>
                  </a:lnTo>
                  <a:lnTo>
                    <a:pt x="351" y="1451"/>
                  </a:lnTo>
                  <a:lnTo>
                    <a:pt x="355" y="1451"/>
                  </a:lnTo>
                  <a:lnTo>
                    <a:pt x="359" y="1451"/>
                  </a:lnTo>
                  <a:lnTo>
                    <a:pt x="362" y="1451"/>
                  </a:lnTo>
                  <a:lnTo>
                    <a:pt x="366" y="1451"/>
                  </a:lnTo>
                  <a:lnTo>
                    <a:pt x="370" y="1451"/>
                  </a:lnTo>
                  <a:lnTo>
                    <a:pt x="374" y="1451"/>
                  </a:lnTo>
                  <a:lnTo>
                    <a:pt x="378" y="1451"/>
                  </a:lnTo>
                  <a:lnTo>
                    <a:pt x="381" y="1451"/>
                  </a:lnTo>
                  <a:lnTo>
                    <a:pt x="385" y="1432"/>
                  </a:lnTo>
                  <a:lnTo>
                    <a:pt x="389" y="1432"/>
                  </a:lnTo>
                  <a:lnTo>
                    <a:pt x="396" y="1432"/>
                  </a:lnTo>
                  <a:lnTo>
                    <a:pt x="400" y="1432"/>
                  </a:lnTo>
                  <a:lnTo>
                    <a:pt x="404" y="1432"/>
                  </a:lnTo>
                  <a:lnTo>
                    <a:pt x="408" y="1413"/>
                  </a:lnTo>
                  <a:lnTo>
                    <a:pt x="412" y="1413"/>
                  </a:lnTo>
                  <a:lnTo>
                    <a:pt x="415" y="1413"/>
                  </a:lnTo>
                  <a:lnTo>
                    <a:pt x="415" y="1390"/>
                  </a:lnTo>
                  <a:lnTo>
                    <a:pt x="419" y="1390"/>
                  </a:lnTo>
                  <a:lnTo>
                    <a:pt x="423" y="1390"/>
                  </a:lnTo>
                  <a:lnTo>
                    <a:pt x="427" y="1390"/>
                  </a:lnTo>
                  <a:lnTo>
                    <a:pt x="434" y="1390"/>
                  </a:lnTo>
                  <a:lnTo>
                    <a:pt x="438" y="1371"/>
                  </a:lnTo>
                  <a:lnTo>
                    <a:pt x="442" y="1352"/>
                  </a:lnTo>
                  <a:lnTo>
                    <a:pt x="445" y="1352"/>
                  </a:lnTo>
                  <a:lnTo>
                    <a:pt x="449" y="1352"/>
                  </a:lnTo>
                  <a:lnTo>
                    <a:pt x="457" y="1352"/>
                  </a:lnTo>
                  <a:lnTo>
                    <a:pt x="464" y="1352"/>
                  </a:lnTo>
                  <a:lnTo>
                    <a:pt x="468" y="1352"/>
                  </a:lnTo>
                  <a:lnTo>
                    <a:pt x="472" y="1352"/>
                  </a:lnTo>
                  <a:lnTo>
                    <a:pt x="476" y="1333"/>
                  </a:lnTo>
                  <a:lnTo>
                    <a:pt x="479" y="1311"/>
                  </a:lnTo>
                  <a:lnTo>
                    <a:pt x="479" y="1292"/>
                  </a:lnTo>
                  <a:lnTo>
                    <a:pt x="483" y="1292"/>
                  </a:lnTo>
                  <a:lnTo>
                    <a:pt x="487" y="1292"/>
                  </a:lnTo>
                  <a:lnTo>
                    <a:pt x="491" y="1292"/>
                  </a:lnTo>
                  <a:lnTo>
                    <a:pt x="494" y="1292"/>
                  </a:lnTo>
                  <a:lnTo>
                    <a:pt x="498" y="1292"/>
                  </a:lnTo>
                  <a:lnTo>
                    <a:pt x="506" y="1292"/>
                  </a:lnTo>
                  <a:lnTo>
                    <a:pt x="510" y="1292"/>
                  </a:lnTo>
                  <a:lnTo>
                    <a:pt x="513" y="1292"/>
                  </a:lnTo>
                  <a:lnTo>
                    <a:pt x="513" y="1273"/>
                  </a:lnTo>
                  <a:lnTo>
                    <a:pt x="517" y="1273"/>
                  </a:lnTo>
                  <a:lnTo>
                    <a:pt x="521" y="1273"/>
                  </a:lnTo>
                  <a:lnTo>
                    <a:pt x="521" y="1254"/>
                  </a:lnTo>
                  <a:lnTo>
                    <a:pt x="525" y="1254"/>
                  </a:lnTo>
                  <a:lnTo>
                    <a:pt x="528" y="1254"/>
                  </a:lnTo>
                  <a:lnTo>
                    <a:pt x="536" y="1254"/>
                  </a:lnTo>
                  <a:lnTo>
                    <a:pt x="544" y="1254"/>
                  </a:lnTo>
                  <a:lnTo>
                    <a:pt x="547" y="1231"/>
                  </a:lnTo>
                  <a:lnTo>
                    <a:pt x="551" y="1231"/>
                  </a:lnTo>
                  <a:lnTo>
                    <a:pt x="555" y="1231"/>
                  </a:lnTo>
                  <a:lnTo>
                    <a:pt x="559" y="1231"/>
                  </a:lnTo>
                  <a:lnTo>
                    <a:pt x="566" y="1231"/>
                  </a:lnTo>
                  <a:lnTo>
                    <a:pt x="566" y="1213"/>
                  </a:lnTo>
                  <a:lnTo>
                    <a:pt x="570" y="1213"/>
                  </a:lnTo>
                  <a:lnTo>
                    <a:pt x="570" y="1194"/>
                  </a:lnTo>
                  <a:lnTo>
                    <a:pt x="574" y="1194"/>
                  </a:lnTo>
                  <a:lnTo>
                    <a:pt x="577" y="1194"/>
                  </a:lnTo>
                  <a:lnTo>
                    <a:pt x="581" y="1194"/>
                  </a:lnTo>
                  <a:lnTo>
                    <a:pt x="585" y="1194"/>
                  </a:lnTo>
                  <a:lnTo>
                    <a:pt x="589" y="1194"/>
                  </a:lnTo>
                  <a:lnTo>
                    <a:pt x="593" y="1194"/>
                  </a:lnTo>
                  <a:lnTo>
                    <a:pt x="596" y="1194"/>
                  </a:lnTo>
                  <a:lnTo>
                    <a:pt x="600" y="1194"/>
                  </a:lnTo>
                  <a:lnTo>
                    <a:pt x="604" y="1194"/>
                  </a:lnTo>
                  <a:lnTo>
                    <a:pt x="608" y="1194"/>
                  </a:lnTo>
                  <a:lnTo>
                    <a:pt x="611" y="1175"/>
                  </a:lnTo>
                  <a:lnTo>
                    <a:pt x="615" y="1175"/>
                  </a:lnTo>
                  <a:lnTo>
                    <a:pt x="619" y="1175"/>
                  </a:lnTo>
                  <a:lnTo>
                    <a:pt x="623" y="1175"/>
                  </a:lnTo>
                  <a:lnTo>
                    <a:pt x="626" y="1175"/>
                  </a:lnTo>
                  <a:lnTo>
                    <a:pt x="630" y="1175"/>
                  </a:lnTo>
                  <a:lnTo>
                    <a:pt x="634" y="1175"/>
                  </a:lnTo>
                  <a:lnTo>
                    <a:pt x="634" y="1152"/>
                  </a:lnTo>
                  <a:lnTo>
                    <a:pt x="638" y="1152"/>
                  </a:lnTo>
                  <a:lnTo>
                    <a:pt x="642" y="1133"/>
                  </a:lnTo>
                  <a:lnTo>
                    <a:pt x="645" y="1133"/>
                  </a:lnTo>
                  <a:lnTo>
                    <a:pt x="649" y="1133"/>
                  </a:lnTo>
                  <a:lnTo>
                    <a:pt x="653" y="1114"/>
                  </a:lnTo>
                  <a:lnTo>
                    <a:pt x="653" y="1096"/>
                  </a:lnTo>
                  <a:lnTo>
                    <a:pt x="660" y="1096"/>
                  </a:lnTo>
                  <a:lnTo>
                    <a:pt x="664" y="1096"/>
                  </a:lnTo>
                  <a:lnTo>
                    <a:pt x="668" y="1073"/>
                  </a:lnTo>
                  <a:lnTo>
                    <a:pt x="672" y="1073"/>
                  </a:lnTo>
                  <a:lnTo>
                    <a:pt x="676" y="1073"/>
                  </a:lnTo>
                  <a:lnTo>
                    <a:pt x="679" y="1073"/>
                  </a:lnTo>
                  <a:lnTo>
                    <a:pt x="683" y="1073"/>
                  </a:lnTo>
                  <a:lnTo>
                    <a:pt x="683" y="1054"/>
                  </a:lnTo>
                  <a:lnTo>
                    <a:pt x="687" y="1054"/>
                  </a:lnTo>
                  <a:lnTo>
                    <a:pt x="691" y="1054"/>
                  </a:lnTo>
                  <a:lnTo>
                    <a:pt x="691" y="1035"/>
                  </a:lnTo>
                  <a:lnTo>
                    <a:pt x="694" y="1035"/>
                  </a:lnTo>
                  <a:lnTo>
                    <a:pt x="698" y="1035"/>
                  </a:lnTo>
                  <a:lnTo>
                    <a:pt x="702" y="1035"/>
                  </a:lnTo>
                  <a:lnTo>
                    <a:pt x="702" y="1016"/>
                  </a:lnTo>
                  <a:lnTo>
                    <a:pt x="706" y="1016"/>
                  </a:lnTo>
                  <a:lnTo>
                    <a:pt x="709" y="1016"/>
                  </a:lnTo>
                  <a:lnTo>
                    <a:pt x="713" y="1016"/>
                  </a:lnTo>
                  <a:lnTo>
                    <a:pt x="713" y="994"/>
                  </a:lnTo>
                  <a:lnTo>
                    <a:pt x="713" y="975"/>
                  </a:lnTo>
                  <a:lnTo>
                    <a:pt x="717" y="975"/>
                  </a:lnTo>
                  <a:lnTo>
                    <a:pt x="725" y="975"/>
                  </a:lnTo>
                  <a:lnTo>
                    <a:pt x="728" y="975"/>
                  </a:lnTo>
                  <a:lnTo>
                    <a:pt x="736" y="956"/>
                  </a:lnTo>
                  <a:lnTo>
                    <a:pt x="736" y="933"/>
                  </a:lnTo>
                  <a:lnTo>
                    <a:pt x="740" y="933"/>
                  </a:lnTo>
                  <a:lnTo>
                    <a:pt x="743" y="933"/>
                  </a:lnTo>
                  <a:lnTo>
                    <a:pt x="747" y="933"/>
                  </a:lnTo>
                  <a:lnTo>
                    <a:pt x="747" y="914"/>
                  </a:lnTo>
                  <a:lnTo>
                    <a:pt x="747" y="895"/>
                  </a:lnTo>
                  <a:lnTo>
                    <a:pt x="751" y="876"/>
                  </a:lnTo>
                  <a:lnTo>
                    <a:pt x="758" y="876"/>
                  </a:lnTo>
                  <a:lnTo>
                    <a:pt x="762" y="876"/>
                  </a:lnTo>
                  <a:lnTo>
                    <a:pt x="766" y="876"/>
                  </a:lnTo>
                  <a:lnTo>
                    <a:pt x="770" y="876"/>
                  </a:lnTo>
                  <a:lnTo>
                    <a:pt x="777" y="876"/>
                  </a:lnTo>
                  <a:lnTo>
                    <a:pt x="781" y="876"/>
                  </a:lnTo>
                  <a:lnTo>
                    <a:pt x="781" y="854"/>
                  </a:lnTo>
                  <a:lnTo>
                    <a:pt x="785" y="854"/>
                  </a:lnTo>
                  <a:lnTo>
                    <a:pt x="789" y="854"/>
                  </a:lnTo>
                  <a:lnTo>
                    <a:pt x="792" y="854"/>
                  </a:lnTo>
                  <a:lnTo>
                    <a:pt x="796" y="854"/>
                  </a:lnTo>
                  <a:lnTo>
                    <a:pt x="800" y="854"/>
                  </a:lnTo>
                  <a:lnTo>
                    <a:pt x="804" y="854"/>
                  </a:lnTo>
                  <a:lnTo>
                    <a:pt x="808" y="835"/>
                  </a:lnTo>
                  <a:lnTo>
                    <a:pt x="811" y="816"/>
                  </a:lnTo>
                  <a:lnTo>
                    <a:pt x="815" y="816"/>
                  </a:lnTo>
                  <a:lnTo>
                    <a:pt x="819" y="816"/>
                  </a:lnTo>
                  <a:lnTo>
                    <a:pt x="823" y="816"/>
                  </a:lnTo>
                  <a:lnTo>
                    <a:pt x="830" y="797"/>
                  </a:lnTo>
                  <a:lnTo>
                    <a:pt x="834" y="797"/>
                  </a:lnTo>
                  <a:lnTo>
                    <a:pt x="841" y="797"/>
                  </a:lnTo>
                  <a:lnTo>
                    <a:pt x="849" y="797"/>
                  </a:lnTo>
                  <a:lnTo>
                    <a:pt x="857" y="797"/>
                  </a:lnTo>
                  <a:lnTo>
                    <a:pt x="860" y="775"/>
                  </a:lnTo>
                  <a:lnTo>
                    <a:pt x="864" y="775"/>
                  </a:lnTo>
                  <a:lnTo>
                    <a:pt x="872" y="775"/>
                  </a:lnTo>
                  <a:lnTo>
                    <a:pt x="875" y="775"/>
                  </a:lnTo>
                  <a:lnTo>
                    <a:pt x="883" y="775"/>
                  </a:lnTo>
                  <a:lnTo>
                    <a:pt x="883" y="756"/>
                  </a:lnTo>
                  <a:lnTo>
                    <a:pt x="887" y="756"/>
                  </a:lnTo>
                  <a:lnTo>
                    <a:pt x="890" y="756"/>
                  </a:lnTo>
                  <a:lnTo>
                    <a:pt x="894" y="756"/>
                  </a:lnTo>
                  <a:lnTo>
                    <a:pt x="902" y="737"/>
                  </a:lnTo>
                  <a:lnTo>
                    <a:pt x="906" y="737"/>
                  </a:lnTo>
                  <a:lnTo>
                    <a:pt x="909" y="737"/>
                  </a:lnTo>
                  <a:lnTo>
                    <a:pt x="917" y="737"/>
                  </a:lnTo>
                  <a:lnTo>
                    <a:pt x="921" y="737"/>
                  </a:lnTo>
                  <a:lnTo>
                    <a:pt x="924" y="737"/>
                  </a:lnTo>
                  <a:lnTo>
                    <a:pt x="928" y="737"/>
                  </a:lnTo>
                  <a:lnTo>
                    <a:pt x="932" y="737"/>
                  </a:lnTo>
                  <a:lnTo>
                    <a:pt x="936" y="737"/>
                  </a:lnTo>
                  <a:lnTo>
                    <a:pt x="940" y="737"/>
                  </a:lnTo>
                  <a:lnTo>
                    <a:pt x="947" y="737"/>
                  </a:lnTo>
                  <a:lnTo>
                    <a:pt x="951" y="737"/>
                  </a:lnTo>
                  <a:lnTo>
                    <a:pt x="955" y="737"/>
                  </a:lnTo>
                  <a:lnTo>
                    <a:pt x="958" y="737"/>
                  </a:lnTo>
                  <a:lnTo>
                    <a:pt x="962" y="737"/>
                  </a:lnTo>
                  <a:lnTo>
                    <a:pt x="966" y="737"/>
                  </a:lnTo>
                  <a:lnTo>
                    <a:pt x="970" y="737"/>
                  </a:lnTo>
                  <a:lnTo>
                    <a:pt x="973" y="737"/>
                  </a:lnTo>
                  <a:lnTo>
                    <a:pt x="977" y="737"/>
                  </a:lnTo>
                  <a:lnTo>
                    <a:pt x="977" y="718"/>
                  </a:lnTo>
                  <a:lnTo>
                    <a:pt x="981" y="718"/>
                  </a:lnTo>
                  <a:lnTo>
                    <a:pt x="985" y="718"/>
                  </a:lnTo>
                  <a:lnTo>
                    <a:pt x="989" y="718"/>
                  </a:lnTo>
                  <a:lnTo>
                    <a:pt x="992" y="718"/>
                  </a:lnTo>
                  <a:lnTo>
                    <a:pt x="996" y="695"/>
                  </a:lnTo>
                  <a:lnTo>
                    <a:pt x="1000" y="695"/>
                  </a:lnTo>
                  <a:lnTo>
                    <a:pt x="1004" y="695"/>
                  </a:lnTo>
                  <a:lnTo>
                    <a:pt x="1007" y="695"/>
                  </a:lnTo>
                  <a:lnTo>
                    <a:pt x="1011" y="695"/>
                  </a:lnTo>
                  <a:lnTo>
                    <a:pt x="1015" y="695"/>
                  </a:lnTo>
                  <a:lnTo>
                    <a:pt x="1019" y="695"/>
                  </a:lnTo>
                  <a:lnTo>
                    <a:pt x="1022" y="695"/>
                  </a:lnTo>
                  <a:lnTo>
                    <a:pt x="1026" y="695"/>
                  </a:lnTo>
                  <a:lnTo>
                    <a:pt x="1030" y="695"/>
                  </a:lnTo>
                  <a:lnTo>
                    <a:pt x="1034" y="695"/>
                  </a:lnTo>
                  <a:lnTo>
                    <a:pt x="1038" y="695"/>
                  </a:lnTo>
                  <a:lnTo>
                    <a:pt x="1041" y="695"/>
                  </a:lnTo>
                  <a:lnTo>
                    <a:pt x="1045" y="695"/>
                  </a:lnTo>
                  <a:lnTo>
                    <a:pt x="1049" y="695"/>
                  </a:lnTo>
                  <a:lnTo>
                    <a:pt x="1053" y="695"/>
                  </a:lnTo>
                  <a:lnTo>
                    <a:pt x="1056" y="695"/>
                  </a:lnTo>
                  <a:lnTo>
                    <a:pt x="1060" y="695"/>
                  </a:lnTo>
                  <a:lnTo>
                    <a:pt x="1064" y="695"/>
                  </a:lnTo>
                  <a:lnTo>
                    <a:pt x="1068" y="695"/>
                  </a:lnTo>
                  <a:lnTo>
                    <a:pt x="1071" y="695"/>
                  </a:lnTo>
                  <a:lnTo>
                    <a:pt x="1075" y="695"/>
                  </a:lnTo>
                  <a:lnTo>
                    <a:pt x="1079" y="695"/>
                  </a:lnTo>
                  <a:lnTo>
                    <a:pt x="1083" y="676"/>
                  </a:lnTo>
                  <a:lnTo>
                    <a:pt x="1090" y="676"/>
                  </a:lnTo>
                  <a:lnTo>
                    <a:pt x="1090" y="657"/>
                  </a:lnTo>
                  <a:lnTo>
                    <a:pt x="1094" y="657"/>
                  </a:lnTo>
                  <a:lnTo>
                    <a:pt x="1117" y="657"/>
                  </a:lnTo>
                  <a:lnTo>
                    <a:pt x="1117" y="639"/>
                  </a:lnTo>
                  <a:lnTo>
                    <a:pt x="1121" y="639"/>
                  </a:lnTo>
                  <a:lnTo>
                    <a:pt x="1124" y="639"/>
                  </a:lnTo>
                  <a:lnTo>
                    <a:pt x="1128" y="639"/>
                  </a:lnTo>
                  <a:lnTo>
                    <a:pt x="1132" y="639"/>
                  </a:lnTo>
                  <a:lnTo>
                    <a:pt x="1139" y="639"/>
                  </a:lnTo>
                  <a:lnTo>
                    <a:pt x="1143" y="639"/>
                  </a:lnTo>
                  <a:lnTo>
                    <a:pt x="1147" y="639"/>
                  </a:lnTo>
                  <a:lnTo>
                    <a:pt x="1151" y="639"/>
                  </a:lnTo>
                  <a:lnTo>
                    <a:pt x="1158" y="639"/>
                  </a:lnTo>
                  <a:lnTo>
                    <a:pt x="1162" y="639"/>
                  </a:lnTo>
                  <a:lnTo>
                    <a:pt x="1166" y="639"/>
                  </a:lnTo>
                  <a:lnTo>
                    <a:pt x="1170" y="639"/>
                  </a:lnTo>
                  <a:lnTo>
                    <a:pt x="1170" y="616"/>
                  </a:lnTo>
                  <a:lnTo>
                    <a:pt x="1173" y="616"/>
                  </a:lnTo>
                  <a:lnTo>
                    <a:pt x="1173" y="597"/>
                  </a:lnTo>
                  <a:lnTo>
                    <a:pt x="1177" y="597"/>
                  </a:lnTo>
                  <a:lnTo>
                    <a:pt x="1181" y="597"/>
                  </a:lnTo>
                  <a:lnTo>
                    <a:pt x="1181" y="578"/>
                  </a:lnTo>
                  <a:lnTo>
                    <a:pt x="1185" y="578"/>
                  </a:lnTo>
                  <a:lnTo>
                    <a:pt x="1188" y="578"/>
                  </a:lnTo>
                  <a:lnTo>
                    <a:pt x="1192" y="578"/>
                  </a:lnTo>
                  <a:lnTo>
                    <a:pt x="1196" y="578"/>
                  </a:lnTo>
                  <a:lnTo>
                    <a:pt x="1203" y="578"/>
                  </a:lnTo>
                  <a:lnTo>
                    <a:pt x="1207" y="578"/>
                  </a:lnTo>
                  <a:lnTo>
                    <a:pt x="1215" y="578"/>
                  </a:lnTo>
                  <a:lnTo>
                    <a:pt x="1219" y="578"/>
                  </a:lnTo>
                  <a:lnTo>
                    <a:pt x="1222" y="578"/>
                  </a:lnTo>
                  <a:lnTo>
                    <a:pt x="1226" y="578"/>
                  </a:lnTo>
                  <a:lnTo>
                    <a:pt x="1230" y="578"/>
                  </a:lnTo>
                  <a:lnTo>
                    <a:pt x="1234" y="578"/>
                  </a:lnTo>
                  <a:lnTo>
                    <a:pt x="1237" y="578"/>
                  </a:lnTo>
                  <a:lnTo>
                    <a:pt x="1241" y="578"/>
                  </a:lnTo>
                  <a:lnTo>
                    <a:pt x="1245" y="578"/>
                  </a:lnTo>
                  <a:lnTo>
                    <a:pt x="1249" y="578"/>
                  </a:lnTo>
                  <a:lnTo>
                    <a:pt x="1256" y="578"/>
                  </a:lnTo>
                  <a:lnTo>
                    <a:pt x="1260" y="578"/>
                  </a:lnTo>
                  <a:lnTo>
                    <a:pt x="1264" y="578"/>
                  </a:lnTo>
                  <a:lnTo>
                    <a:pt x="1268" y="578"/>
                  </a:lnTo>
                  <a:lnTo>
                    <a:pt x="1271" y="559"/>
                  </a:lnTo>
                  <a:lnTo>
                    <a:pt x="1275" y="559"/>
                  </a:lnTo>
                  <a:lnTo>
                    <a:pt x="1279" y="559"/>
                  </a:lnTo>
                  <a:lnTo>
                    <a:pt x="1283" y="559"/>
                  </a:lnTo>
                  <a:lnTo>
                    <a:pt x="1286" y="559"/>
                  </a:lnTo>
                  <a:lnTo>
                    <a:pt x="1290" y="559"/>
                  </a:lnTo>
                  <a:lnTo>
                    <a:pt x="1294" y="559"/>
                  </a:lnTo>
                  <a:lnTo>
                    <a:pt x="1298" y="559"/>
                  </a:lnTo>
                  <a:lnTo>
                    <a:pt x="1302" y="559"/>
                  </a:lnTo>
                  <a:lnTo>
                    <a:pt x="1309" y="559"/>
                  </a:lnTo>
                  <a:lnTo>
                    <a:pt x="1313" y="559"/>
                  </a:lnTo>
                  <a:lnTo>
                    <a:pt x="1317" y="559"/>
                  </a:lnTo>
                  <a:lnTo>
                    <a:pt x="1324" y="559"/>
                  </a:lnTo>
                  <a:lnTo>
                    <a:pt x="1328" y="559"/>
                  </a:lnTo>
                  <a:lnTo>
                    <a:pt x="1332" y="559"/>
                  </a:lnTo>
                  <a:lnTo>
                    <a:pt x="1332" y="537"/>
                  </a:lnTo>
                  <a:lnTo>
                    <a:pt x="1339" y="537"/>
                  </a:lnTo>
                  <a:lnTo>
                    <a:pt x="1343" y="537"/>
                  </a:lnTo>
                  <a:lnTo>
                    <a:pt x="1347" y="537"/>
                  </a:lnTo>
                  <a:lnTo>
                    <a:pt x="1351" y="537"/>
                  </a:lnTo>
                  <a:lnTo>
                    <a:pt x="1354" y="537"/>
                  </a:lnTo>
                  <a:lnTo>
                    <a:pt x="1358" y="537"/>
                  </a:lnTo>
                  <a:lnTo>
                    <a:pt x="1362" y="537"/>
                  </a:lnTo>
                  <a:lnTo>
                    <a:pt x="1366" y="537"/>
                  </a:lnTo>
                  <a:lnTo>
                    <a:pt x="1369" y="537"/>
                  </a:lnTo>
                  <a:lnTo>
                    <a:pt x="1373" y="537"/>
                  </a:lnTo>
                  <a:lnTo>
                    <a:pt x="1377" y="537"/>
                  </a:lnTo>
                  <a:lnTo>
                    <a:pt x="1381" y="537"/>
                  </a:lnTo>
                  <a:lnTo>
                    <a:pt x="1385" y="537"/>
                  </a:lnTo>
                  <a:lnTo>
                    <a:pt x="1388" y="537"/>
                  </a:lnTo>
                  <a:lnTo>
                    <a:pt x="1392" y="537"/>
                  </a:lnTo>
                  <a:lnTo>
                    <a:pt x="1396" y="537"/>
                  </a:lnTo>
                  <a:lnTo>
                    <a:pt x="1400" y="537"/>
                  </a:lnTo>
                  <a:lnTo>
                    <a:pt x="1403" y="518"/>
                  </a:lnTo>
                  <a:lnTo>
                    <a:pt x="1407" y="518"/>
                  </a:lnTo>
                  <a:lnTo>
                    <a:pt x="1411" y="518"/>
                  </a:lnTo>
                  <a:lnTo>
                    <a:pt x="1415" y="518"/>
                  </a:lnTo>
                  <a:lnTo>
                    <a:pt x="1418" y="518"/>
                  </a:lnTo>
                  <a:lnTo>
                    <a:pt x="1422" y="518"/>
                  </a:lnTo>
                  <a:lnTo>
                    <a:pt x="1426" y="518"/>
                  </a:lnTo>
                  <a:lnTo>
                    <a:pt x="1434" y="518"/>
                  </a:lnTo>
                  <a:lnTo>
                    <a:pt x="1437" y="518"/>
                  </a:lnTo>
                  <a:lnTo>
                    <a:pt x="1441" y="499"/>
                  </a:lnTo>
                  <a:lnTo>
                    <a:pt x="1445" y="499"/>
                  </a:lnTo>
                  <a:lnTo>
                    <a:pt x="1449" y="499"/>
                  </a:lnTo>
                  <a:lnTo>
                    <a:pt x="1449" y="480"/>
                  </a:lnTo>
                  <a:lnTo>
                    <a:pt x="1452" y="480"/>
                  </a:lnTo>
                  <a:lnTo>
                    <a:pt x="1456" y="480"/>
                  </a:lnTo>
                  <a:lnTo>
                    <a:pt x="1460" y="480"/>
                  </a:lnTo>
                  <a:lnTo>
                    <a:pt x="1467" y="480"/>
                  </a:lnTo>
                  <a:lnTo>
                    <a:pt x="1467" y="457"/>
                  </a:lnTo>
                  <a:lnTo>
                    <a:pt x="1471" y="457"/>
                  </a:lnTo>
                  <a:lnTo>
                    <a:pt x="1475" y="457"/>
                  </a:lnTo>
                  <a:lnTo>
                    <a:pt x="1479" y="457"/>
                  </a:lnTo>
                  <a:lnTo>
                    <a:pt x="1483" y="457"/>
                  </a:lnTo>
                  <a:lnTo>
                    <a:pt x="1483" y="438"/>
                  </a:lnTo>
                  <a:lnTo>
                    <a:pt x="1486" y="438"/>
                  </a:lnTo>
                  <a:lnTo>
                    <a:pt x="1490" y="438"/>
                  </a:lnTo>
                  <a:lnTo>
                    <a:pt x="1494" y="438"/>
                  </a:lnTo>
                  <a:lnTo>
                    <a:pt x="1498" y="438"/>
                  </a:lnTo>
                  <a:lnTo>
                    <a:pt x="1501" y="438"/>
                  </a:lnTo>
                  <a:lnTo>
                    <a:pt x="1505" y="438"/>
                  </a:lnTo>
                  <a:lnTo>
                    <a:pt x="1509" y="438"/>
                  </a:lnTo>
                  <a:lnTo>
                    <a:pt x="1513" y="438"/>
                  </a:lnTo>
                  <a:lnTo>
                    <a:pt x="1517" y="438"/>
                  </a:lnTo>
                  <a:lnTo>
                    <a:pt x="1520" y="438"/>
                  </a:lnTo>
                  <a:lnTo>
                    <a:pt x="1524" y="438"/>
                  </a:lnTo>
                  <a:lnTo>
                    <a:pt x="1528" y="438"/>
                  </a:lnTo>
                  <a:lnTo>
                    <a:pt x="1532" y="438"/>
                  </a:lnTo>
                  <a:lnTo>
                    <a:pt x="1532" y="420"/>
                  </a:lnTo>
                  <a:lnTo>
                    <a:pt x="1535" y="420"/>
                  </a:lnTo>
                  <a:lnTo>
                    <a:pt x="1539" y="420"/>
                  </a:lnTo>
                  <a:lnTo>
                    <a:pt x="1539" y="401"/>
                  </a:lnTo>
                  <a:lnTo>
                    <a:pt x="1543" y="401"/>
                  </a:lnTo>
                  <a:lnTo>
                    <a:pt x="1543" y="378"/>
                  </a:lnTo>
                  <a:lnTo>
                    <a:pt x="1543" y="359"/>
                  </a:lnTo>
                  <a:lnTo>
                    <a:pt x="1550" y="359"/>
                  </a:lnTo>
                  <a:lnTo>
                    <a:pt x="1550" y="340"/>
                  </a:lnTo>
                  <a:lnTo>
                    <a:pt x="1554" y="340"/>
                  </a:lnTo>
                  <a:lnTo>
                    <a:pt x="1554" y="321"/>
                  </a:lnTo>
                  <a:lnTo>
                    <a:pt x="1558" y="321"/>
                  </a:lnTo>
                  <a:lnTo>
                    <a:pt x="1562" y="321"/>
                  </a:lnTo>
                  <a:lnTo>
                    <a:pt x="1566" y="321"/>
                  </a:lnTo>
                  <a:lnTo>
                    <a:pt x="1569" y="321"/>
                  </a:lnTo>
                  <a:lnTo>
                    <a:pt x="1577" y="321"/>
                  </a:lnTo>
                  <a:lnTo>
                    <a:pt x="1581" y="321"/>
                  </a:lnTo>
                  <a:lnTo>
                    <a:pt x="1584" y="321"/>
                  </a:lnTo>
                  <a:lnTo>
                    <a:pt x="1588" y="321"/>
                  </a:lnTo>
                  <a:lnTo>
                    <a:pt x="1588" y="299"/>
                  </a:lnTo>
                  <a:lnTo>
                    <a:pt x="1592" y="299"/>
                  </a:lnTo>
                  <a:lnTo>
                    <a:pt x="1596" y="299"/>
                  </a:lnTo>
                  <a:lnTo>
                    <a:pt x="1599" y="299"/>
                  </a:lnTo>
                  <a:lnTo>
                    <a:pt x="1603" y="299"/>
                  </a:lnTo>
                  <a:lnTo>
                    <a:pt x="1607" y="299"/>
                  </a:lnTo>
                  <a:lnTo>
                    <a:pt x="1615" y="299"/>
                  </a:lnTo>
                  <a:lnTo>
                    <a:pt x="1615" y="280"/>
                  </a:lnTo>
                  <a:lnTo>
                    <a:pt x="1615" y="261"/>
                  </a:lnTo>
                  <a:lnTo>
                    <a:pt x="1618" y="261"/>
                  </a:lnTo>
                  <a:lnTo>
                    <a:pt x="1622" y="242"/>
                  </a:lnTo>
                  <a:lnTo>
                    <a:pt x="1626" y="242"/>
                  </a:lnTo>
                  <a:lnTo>
                    <a:pt x="1630" y="242"/>
                  </a:lnTo>
                  <a:lnTo>
                    <a:pt x="1633" y="242"/>
                  </a:lnTo>
                  <a:lnTo>
                    <a:pt x="1637" y="242"/>
                  </a:lnTo>
                  <a:lnTo>
                    <a:pt x="1641" y="242"/>
                  </a:lnTo>
                  <a:lnTo>
                    <a:pt x="1645" y="242"/>
                  </a:lnTo>
                  <a:lnTo>
                    <a:pt x="1648" y="242"/>
                  </a:lnTo>
                  <a:lnTo>
                    <a:pt x="1652" y="242"/>
                  </a:lnTo>
                  <a:lnTo>
                    <a:pt x="1656" y="242"/>
                  </a:lnTo>
                  <a:lnTo>
                    <a:pt x="1656" y="219"/>
                  </a:lnTo>
                  <a:lnTo>
                    <a:pt x="1660" y="219"/>
                  </a:lnTo>
                  <a:lnTo>
                    <a:pt x="1664" y="219"/>
                  </a:lnTo>
                  <a:lnTo>
                    <a:pt x="1667" y="219"/>
                  </a:lnTo>
                  <a:lnTo>
                    <a:pt x="1671" y="219"/>
                  </a:lnTo>
                  <a:lnTo>
                    <a:pt x="1675" y="219"/>
                  </a:lnTo>
                  <a:lnTo>
                    <a:pt x="1679" y="219"/>
                  </a:lnTo>
                  <a:lnTo>
                    <a:pt x="1682" y="219"/>
                  </a:lnTo>
                  <a:lnTo>
                    <a:pt x="1682" y="200"/>
                  </a:lnTo>
                  <a:lnTo>
                    <a:pt x="1686" y="200"/>
                  </a:lnTo>
                  <a:lnTo>
                    <a:pt x="1690" y="200"/>
                  </a:lnTo>
                  <a:lnTo>
                    <a:pt x="1694" y="200"/>
                  </a:lnTo>
                  <a:lnTo>
                    <a:pt x="1698" y="200"/>
                  </a:lnTo>
                  <a:lnTo>
                    <a:pt x="1698" y="182"/>
                  </a:lnTo>
                  <a:lnTo>
                    <a:pt x="1701" y="182"/>
                  </a:lnTo>
                  <a:lnTo>
                    <a:pt x="1705" y="182"/>
                  </a:lnTo>
                  <a:lnTo>
                    <a:pt x="1709" y="182"/>
                  </a:lnTo>
                  <a:lnTo>
                    <a:pt x="1713" y="182"/>
                  </a:lnTo>
                  <a:lnTo>
                    <a:pt x="1716" y="182"/>
                  </a:lnTo>
                  <a:lnTo>
                    <a:pt x="1720" y="182"/>
                  </a:lnTo>
                  <a:lnTo>
                    <a:pt x="1728" y="182"/>
                  </a:lnTo>
                  <a:lnTo>
                    <a:pt x="1731" y="182"/>
                  </a:lnTo>
                  <a:lnTo>
                    <a:pt x="1735" y="182"/>
                  </a:lnTo>
                  <a:lnTo>
                    <a:pt x="1739" y="182"/>
                  </a:lnTo>
                  <a:lnTo>
                    <a:pt x="1743" y="182"/>
                  </a:lnTo>
                  <a:lnTo>
                    <a:pt x="1747" y="182"/>
                  </a:lnTo>
                  <a:lnTo>
                    <a:pt x="1750" y="182"/>
                  </a:lnTo>
                  <a:lnTo>
                    <a:pt x="1754" y="182"/>
                  </a:lnTo>
                  <a:lnTo>
                    <a:pt x="1758" y="182"/>
                  </a:lnTo>
                  <a:lnTo>
                    <a:pt x="1762" y="182"/>
                  </a:lnTo>
                  <a:lnTo>
                    <a:pt x="1765" y="182"/>
                  </a:lnTo>
                  <a:lnTo>
                    <a:pt x="1769" y="182"/>
                  </a:lnTo>
                  <a:lnTo>
                    <a:pt x="1773" y="182"/>
                  </a:lnTo>
                  <a:lnTo>
                    <a:pt x="1777" y="182"/>
                  </a:lnTo>
                  <a:lnTo>
                    <a:pt x="1777" y="163"/>
                  </a:lnTo>
                  <a:lnTo>
                    <a:pt x="1777" y="140"/>
                  </a:lnTo>
                  <a:lnTo>
                    <a:pt x="1780" y="140"/>
                  </a:lnTo>
                  <a:lnTo>
                    <a:pt x="1784" y="121"/>
                  </a:lnTo>
                  <a:lnTo>
                    <a:pt x="1788" y="121"/>
                  </a:lnTo>
                  <a:lnTo>
                    <a:pt x="1792" y="121"/>
                  </a:lnTo>
                  <a:lnTo>
                    <a:pt x="1796" y="121"/>
                  </a:lnTo>
                  <a:lnTo>
                    <a:pt x="1799" y="121"/>
                  </a:lnTo>
                  <a:lnTo>
                    <a:pt x="1803" y="121"/>
                  </a:lnTo>
                  <a:lnTo>
                    <a:pt x="1807" y="121"/>
                  </a:lnTo>
                  <a:lnTo>
                    <a:pt x="1811" y="121"/>
                  </a:lnTo>
                  <a:lnTo>
                    <a:pt x="1814" y="121"/>
                  </a:lnTo>
                  <a:lnTo>
                    <a:pt x="1818" y="121"/>
                  </a:lnTo>
                  <a:lnTo>
                    <a:pt x="1822" y="102"/>
                  </a:lnTo>
                  <a:lnTo>
                    <a:pt x="1822" y="83"/>
                  </a:lnTo>
                  <a:lnTo>
                    <a:pt x="1826" y="83"/>
                  </a:lnTo>
                  <a:lnTo>
                    <a:pt x="1833" y="83"/>
                  </a:lnTo>
                  <a:lnTo>
                    <a:pt x="1837" y="83"/>
                  </a:lnTo>
                  <a:lnTo>
                    <a:pt x="1841" y="83"/>
                  </a:lnTo>
                  <a:lnTo>
                    <a:pt x="1845" y="83"/>
                  </a:lnTo>
                  <a:lnTo>
                    <a:pt x="1848" y="83"/>
                  </a:lnTo>
                  <a:lnTo>
                    <a:pt x="1852" y="83"/>
                  </a:lnTo>
                  <a:lnTo>
                    <a:pt x="1856" y="83"/>
                  </a:lnTo>
                  <a:lnTo>
                    <a:pt x="1863" y="83"/>
                  </a:lnTo>
                  <a:lnTo>
                    <a:pt x="1863" y="61"/>
                  </a:lnTo>
                  <a:lnTo>
                    <a:pt x="1867" y="61"/>
                  </a:lnTo>
                  <a:lnTo>
                    <a:pt x="1871" y="61"/>
                  </a:lnTo>
                  <a:lnTo>
                    <a:pt x="1875" y="61"/>
                  </a:lnTo>
                  <a:lnTo>
                    <a:pt x="1879" y="61"/>
                  </a:lnTo>
                  <a:lnTo>
                    <a:pt x="1882" y="61"/>
                  </a:lnTo>
                  <a:lnTo>
                    <a:pt x="1886" y="61"/>
                  </a:lnTo>
                  <a:lnTo>
                    <a:pt x="1890" y="61"/>
                  </a:lnTo>
                  <a:lnTo>
                    <a:pt x="1894" y="61"/>
                  </a:lnTo>
                  <a:lnTo>
                    <a:pt x="1897" y="61"/>
                  </a:lnTo>
                  <a:lnTo>
                    <a:pt x="1901" y="61"/>
                  </a:lnTo>
                  <a:lnTo>
                    <a:pt x="1905" y="61"/>
                  </a:lnTo>
                  <a:lnTo>
                    <a:pt x="1909" y="61"/>
                  </a:lnTo>
                  <a:lnTo>
                    <a:pt x="1912" y="42"/>
                  </a:lnTo>
                  <a:lnTo>
                    <a:pt x="1916" y="42"/>
                  </a:lnTo>
                  <a:lnTo>
                    <a:pt x="1916" y="23"/>
                  </a:lnTo>
                  <a:lnTo>
                    <a:pt x="1920" y="23"/>
                  </a:lnTo>
                  <a:lnTo>
                    <a:pt x="1924" y="0"/>
                  </a:lnTo>
                  <a:lnTo>
                    <a:pt x="1928" y="0"/>
                  </a:lnTo>
                  <a:lnTo>
                    <a:pt x="1931" y="0"/>
                  </a:lnTo>
                  <a:lnTo>
                    <a:pt x="1935" y="0"/>
                  </a:lnTo>
                  <a:lnTo>
                    <a:pt x="1939" y="0"/>
                  </a:lnTo>
                  <a:lnTo>
                    <a:pt x="1943" y="0"/>
                  </a:lnTo>
                </a:path>
              </a:pathLst>
            </a:custGeom>
            <a:noFill/>
            <a:ln w="57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1157400" y="2082960"/>
              <a:ext cx="3174840" cy="3165480"/>
            </a:xfrm>
            <a:custGeom>
              <a:avLst/>
              <a:gdLst/>
              <a:ahLst/>
              <a:rect l="l" t="t" r="r" b="b"/>
              <a:pathLst>
                <a:path w="1943" h="1945">
                  <a:moveTo>
                    <a:pt x="0" y="1945"/>
                  </a:moveTo>
                  <a:lnTo>
                    <a:pt x="16" y="1945"/>
                  </a:lnTo>
                  <a:lnTo>
                    <a:pt x="23" y="1945"/>
                  </a:lnTo>
                  <a:lnTo>
                    <a:pt x="27" y="1945"/>
                  </a:lnTo>
                  <a:lnTo>
                    <a:pt x="34" y="1941"/>
                  </a:lnTo>
                  <a:lnTo>
                    <a:pt x="38" y="1941"/>
                  </a:lnTo>
                  <a:lnTo>
                    <a:pt x="42" y="1941"/>
                  </a:lnTo>
                  <a:lnTo>
                    <a:pt x="49" y="1941"/>
                  </a:lnTo>
                  <a:lnTo>
                    <a:pt x="53" y="1941"/>
                  </a:lnTo>
                  <a:lnTo>
                    <a:pt x="61" y="1941"/>
                  </a:lnTo>
                  <a:lnTo>
                    <a:pt x="65" y="1941"/>
                  </a:lnTo>
                  <a:lnTo>
                    <a:pt x="72" y="1938"/>
                  </a:lnTo>
                  <a:lnTo>
                    <a:pt x="76" y="1938"/>
                  </a:lnTo>
                  <a:lnTo>
                    <a:pt x="80" y="1938"/>
                  </a:lnTo>
                  <a:lnTo>
                    <a:pt x="83" y="1938"/>
                  </a:lnTo>
                  <a:lnTo>
                    <a:pt x="87" y="1938"/>
                  </a:lnTo>
                  <a:lnTo>
                    <a:pt x="91" y="1930"/>
                  </a:lnTo>
                  <a:lnTo>
                    <a:pt x="95" y="1930"/>
                  </a:lnTo>
                  <a:lnTo>
                    <a:pt x="95" y="1923"/>
                  </a:lnTo>
                  <a:lnTo>
                    <a:pt x="99" y="1915"/>
                  </a:lnTo>
                  <a:lnTo>
                    <a:pt x="102" y="1915"/>
                  </a:lnTo>
                  <a:lnTo>
                    <a:pt x="110" y="1915"/>
                  </a:lnTo>
                  <a:lnTo>
                    <a:pt x="114" y="1915"/>
                  </a:lnTo>
                  <a:lnTo>
                    <a:pt x="117" y="1915"/>
                  </a:lnTo>
                  <a:lnTo>
                    <a:pt x="121" y="1915"/>
                  </a:lnTo>
                  <a:lnTo>
                    <a:pt x="125" y="1915"/>
                  </a:lnTo>
                  <a:lnTo>
                    <a:pt x="129" y="1915"/>
                  </a:lnTo>
                  <a:lnTo>
                    <a:pt x="132" y="1915"/>
                  </a:lnTo>
                  <a:lnTo>
                    <a:pt x="136" y="1904"/>
                  </a:lnTo>
                  <a:lnTo>
                    <a:pt x="140" y="1904"/>
                  </a:lnTo>
                  <a:lnTo>
                    <a:pt x="148" y="1904"/>
                  </a:lnTo>
                  <a:lnTo>
                    <a:pt x="151" y="1904"/>
                  </a:lnTo>
                  <a:lnTo>
                    <a:pt x="155" y="1904"/>
                  </a:lnTo>
                  <a:lnTo>
                    <a:pt x="159" y="1904"/>
                  </a:lnTo>
                  <a:lnTo>
                    <a:pt x="163" y="1904"/>
                  </a:lnTo>
                  <a:lnTo>
                    <a:pt x="166" y="1904"/>
                  </a:lnTo>
                  <a:lnTo>
                    <a:pt x="170" y="1904"/>
                  </a:lnTo>
                  <a:lnTo>
                    <a:pt x="174" y="1904"/>
                  </a:lnTo>
                  <a:lnTo>
                    <a:pt x="178" y="1904"/>
                  </a:lnTo>
                  <a:lnTo>
                    <a:pt x="178" y="1892"/>
                  </a:lnTo>
                  <a:lnTo>
                    <a:pt x="181" y="1892"/>
                  </a:lnTo>
                  <a:lnTo>
                    <a:pt x="181" y="1881"/>
                  </a:lnTo>
                  <a:lnTo>
                    <a:pt x="181" y="1870"/>
                  </a:lnTo>
                  <a:lnTo>
                    <a:pt x="185" y="1870"/>
                  </a:lnTo>
                  <a:lnTo>
                    <a:pt x="185" y="1855"/>
                  </a:lnTo>
                  <a:lnTo>
                    <a:pt x="189" y="1855"/>
                  </a:lnTo>
                  <a:lnTo>
                    <a:pt x="193" y="1855"/>
                  </a:lnTo>
                  <a:lnTo>
                    <a:pt x="197" y="1855"/>
                  </a:lnTo>
                  <a:lnTo>
                    <a:pt x="200" y="1855"/>
                  </a:lnTo>
                  <a:lnTo>
                    <a:pt x="204" y="1855"/>
                  </a:lnTo>
                  <a:lnTo>
                    <a:pt x="208" y="1855"/>
                  </a:lnTo>
                  <a:lnTo>
                    <a:pt x="212" y="1855"/>
                  </a:lnTo>
                  <a:lnTo>
                    <a:pt x="215" y="1855"/>
                  </a:lnTo>
                  <a:lnTo>
                    <a:pt x="219" y="1855"/>
                  </a:lnTo>
                  <a:lnTo>
                    <a:pt x="223" y="1855"/>
                  </a:lnTo>
                  <a:lnTo>
                    <a:pt x="227" y="1843"/>
                  </a:lnTo>
                  <a:lnTo>
                    <a:pt x="231" y="1843"/>
                  </a:lnTo>
                  <a:lnTo>
                    <a:pt x="234" y="1843"/>
                  </a:lnTo>
                  <a:lnTo>
                    <a:pt x="238" y="1843"/>
                  </a:lnTo>
                  <a:lnTo>
                    <a:pt x="238" y="1828"/>
                  </a:lnTo>
                  <a:lnTo>
                    <a:pt x="242" y="1828"/>
                  </a:lnTo>
                  <a:lnTo>
                    <a:pt x="242" y="1817"/>
                  </a:lnTo>
                  <a:lnTo>
                    <a:pt x="246" y="1817"/>
                  </a:lnTo>
                  <a:lnTo>
                    <a:pt x="253" y="1817"/>
                  </a:lnTo>
                  <a:lnTo>
                    <a:pt x="257" y="1817"/>
                  </a:lnTo>
                  <a:lnTo>
                    <a:pt x="264" y="1817"/>
                  </a:lnTo>
                  <a:lnTo>
                    <a:pt x="268" y="1817"/>
                  </a:lnTo>
                  <a:lnTo>
                    <a:pt x="272" y="1817"/>
                  </a:lnTo>
                  <a:lnTo>
                    <a:pt x="272" y="1802"/>
                  </a:lnTo>
                  <a:lnTo>
                    <a:pt x="276" y="1802"/>
                  </a:lnTo>
                  <a:lnTo>
                    <a:pt x="276" y="1787"/>
                  </a:lnTo>
                  <a:lnTo>
                    <a:pt x="276" y="1772"/>
                  </a:lnTo>
                  <a:lnTo>
                    <a:pt x="280" y="1772"/>
                  </a:lnTo>
                  <a:lnTo>
                    <a:pt x="291" y="1772"/>
                  </a:lnTo>
                  <a:lnTo>
                    <a:pt x="295" y="1772"/>
                  </a:lnTo>
                  <a:lnTo>
                    <a:pt x="295" y="1756"/>
                  </a:lnTo>
                  <a:lnTo>
                    <a:pt x="298" y="1756"/>
                  </a:lnTo>
                  <a:lnTo>
                    <a:pt x="302" y="1756"/>
                  </a:lnTo>
                  <a:lnTo>
                    <a:pt x="306" y="1756"/>
                  </a:lnTo>
                  <a:lnTo>
                    <a:pt x="313" y="1756"/>
                  </a:lnTo>
                  <a:lnTo>
                    <a:pt x="317" y="1756"/>
                  </a:lnTo>
                  <a:lnTo>
                    <a:pt x="321" y="1756"/>
                  </a:lnTo>
                  <a:lnTo>
                    <a:pt x="325" y="1756"/>
                  </a:lnTo>
                  <a:lnTo>
                    <a:pt x="325" y="1741"/>
                  </a:lnTo>
                  <a:lnTo>
                    <a:pt x="329" y="1741"/>
                  </a:lnTo>
                  <a:lnTo>
                    <a:pt x="332" y="1741"/>
                  </a:lnTo>
                  <a:lnTo>
                    <a:pt x="336" y="1741"/>
                  </a:lnTo>
                  <a:lnTo>
                    <a:pt x="340" y="1741"/>
                  </a:lnTo>
                  <a:lnTo>
                    <a:pt x="344" y="1741"/>
                  </a:lnTo>
                  <a:lnTo>
                    <a:pt x="347" y="1741"/>
                  </a:lnTo>
                  <a:lnTo>
                    <a:pt x="351" y="1741"/>
                  </a:lnTo>
                  <a:lnTo>
                    <a:pt x="355" y="1726"/>
                  </a:lnTo>
                  <a:lnTo>
                    <a:pt x="359" y="1726"/>
                  </a:lnTo>
                  <a:lnTo>
                    <a:pt x="362" y="1711"/>
                  </a:lnTo>
                  <a:lnTo>
                    <a:pt x="366" y="1711"/>
                  </a:lnTo>
                  <a:lnTo>
                    <a:pt x="370" y="1711"/>
                  </a:lnTo>
                  <a:lnTo>
                    <a:pt x="374" y="1711"/>
                  </a:lnTo>
                  <a:lnTo>
                    <a:pt x="378" y="1696"/>
                  </a:lnTo>
                  <a:lnTo>
                    <a:pt x="381" y="1696"/>
                  </a:lnTo>
                  <a:lnTo>
                    <a:pt x="385" y="1696"/>
                  </a:lnTo>
                  <a:lnTo>
                    <a:pt x="389" y="1696"/>
                  </a:lnTo>
                  <a:lnTo>
                    <a:pt x="396" y="1696"/>
                  </a:lnTo>
                  <a:lnTo>
                    <a:pt x="404" y="1696"/>
                  </a:lnTo>
                  <a:lnTo>
                    <a:pt x="408" y="1696"/>
                  </a:lnTo>
                  <a:lnTo>
                    <a:pt x="412" y="1696"/>
                  </a:lnTo>
                  <a:lnTo>
                    <a:pt x="415" y="1696"/>
                  </a:lnTo>
                  <a:lnTo>
                    <a:pt x="423" y="1696"/>
                  </a:lnTo>
                  <a:lnTo>
                    <a:pt x="423" y="1681"/>
                  </a:lnTo>
                  <a:lnTo>
                    <a:pt x="427" y="1681"/>
                  </a:lnTo>
                  <a:lnTo>
                    <a:pt x="427" y="1666"/>
                  </a:lnTo>
                  <a:lnTo>
                    <a:pt x="430" y="1666"/>
                  </a:lnTo>
                  <a:lnTo>
                    <a:pt x="434" y="1666"/>
                  </a:lnTo>
                  <a:lnTo>
                    <a:pt x="434" y="1647"/>
                  </a:lnTo>
                  <a:lnTo>
                    <a:pt x="438" y="1647"/>
                  </a:lnTo>
                  <a:lnTo>
                    <a:pt x="442" y="1647"/>
                  </a:lnTo>
                  <a:lnTo>
                    <a:pt x="445" y="1647"/>
                  </a:lnTo>
                  <a:lnTo>
                    <a:pt x="449" y="1647"/>
                  </a:lnTo>
                  <a:lnTo>
                    <a:pt x="453" y="1647"/>
                  </a:lnTo>
                  <a:lnTo>
                    <a:pt x="457" y="1647"/>
                  </a:lnTo>
                  <a:lnTo>
                    <a:pt x="461" y="1647"/>
                  </a:lnTo>
                  <a:lnTo>
                    <a:pt x="464" y="1647"/>
                  </a:lnTo>
                  <a:lnTo>
                    <a:pt x="468" y="1647"/>
                  </a:lnTo>
                  <a:lnTo>
                    <a:pt x="472" y="1632"/>
                  </a:lnTo>
                  <a:lnTo>
                    <a:pt x="479" y="1632"/>
                  </a:lnTo>
                  <a:lnTo>
                    <a:pt x="483" y="1632"/>
                  </a:lnTo>
                  <a:lnTo>
                    <a:pt x="487" y="1632"/>
                  </a:lnTo>
                  <a:lnTo>
                    <a:pt x="491" y="1632"/>
                  </a:lnTo>
                  <a:lnTo>
                    <a:pt x="494" y="1617"/>
                  </a:lnTo>
                  <a:lnTo>
                    <a:pt x="498" y="1617"/>
                  </a:lnTo>
                  <a:lnTo>
                    <a:pt x="502" y="1617"/>
                  </a:lnTo>
                  <a:lnTo>
                    <a:pt x="502" y="1598"/>
                  </a:lnTo>
                  <a:lnTo>
                    <a:pt x="510" y="1598"/>
                  </a:lnTo>
                  <a:lnTo>
                    <a:pt x="513" y="1598"/>
                  </a:lnTo>
                  <a:lnTo>
                    <a:pt x="521" y="1598"/>
                  </a:lnTo>
                  <a:lnTo>
                    <a:pt x="525" y="1583"/>
                  </a:lnTo>
                  <a:lnTo>
                    <a:pt x="528" y="1564"/>
                  </a:lnTo>
                  <a:lnTo>
                    <a:pt x="532" y="1564"/>
                  </a:lnTo>
                  <a:lnTo>
                    <a:pt x="536" y="1564"/>
                  </a:lnTo>
                  <a:lnTo>
                    <a:pt x="540" y="1564"/>
                  </a:lnTo>
                  <a:lnTo>
                    <a:pt x="547" y="1564"/>
                  </a:lnTo>
                  <a:lnTo>
                    <a:pt x="551" y="1564"/>
                  </a:lnTo>
                  <a:lnTo>
                    <a:pt x="555" y="1564"/>
                  </a:lnTo>
                  <a:lnTo>
                    <a:pt x="559" y="1564"/>
                  </a:lnTo>
                  <a:lnTo>
                    <a:pt x="562" y="1564"/>
                  </a:lnTo>
                  <a:lnTo>
                    <a:pt x="566" y="1549"/>
                  </a:lnTo>
                  <a:lnTo>
                    <a:pt x="570" y="1530"/>
                  </a:lnTo>
                  <a:lnTo>
                    <a:pt x="570" y="1515"/>
                  </a:lnTo>
                  <a:lnTo>
                    <a:pt x="574" y="1515"/>
                  </a:lnTo>
                  <a:lnTo>
                    <a:pt x="577" y="1515"/>
                  </a:lnTo>
                  <a:lnTo>
                    <a:pt x="585" y="1515"/>
                  </a:lnTo>
                  <a:lnTo>
                    <a:pt x="589" y="1515"/>
                  </a:lnTo>
                  <a:lnTo>
                    <a:pt x="596" y="1515"/>
                  </a:lnTo>
                  <a:lnTo>
                    <a:pt x="600" y="1515"/>
                  </a:lnTo>
                  <a:lnTo>
                    <a:pt x="604" y="1515"/>
                  </a:lnTo>
                  <a:lnTo>
                    <a:pt x="608" y="1496"/>
                  </a:lnTo>
                  <a:lnTo>
                    <a:pt x="611" y="1496"/>
                  </a:lnTo>
                  <a:lnTo>
                    <a:pt x="615" y="1496"/>
                  </a:lnTo>
                  <a:lnTo>
                    <a:pt x="615" y="1481"/>
                  </a:lnTo>
                  <a:lnTo>
                    <a:pt x="619" y="1481"/>
                  </a:lnTo>
                  <a:lnTo>
                    <a:pt x="623" y="1481"/>
                  </a:lnTo>
                  <a:lnTo>
                    <a:pt x="630" y="1481"/>
                  </a:lnTo>
                  <a:lnTo>
                    <a:pt x="638" y="1481"/>
                  </a:lnTo>
                  <a:lnTo>
                    <a:pt x="642" y="1462"/>
                  </a:lnTo>
                  <a:lnTo>
                    <a:pt x="645" y="1462"/>
                  </a:lnTo>
                  <a:lnTo>
                    <a:pt x="649" y="1462"/>
                  </a:lnTo>
                  <a:lnTo>
                    <a:pt x="653" y="1462"/>
                  </a:lnTo>
                  <a:lnTo>
                    <a:pt x="660" y="1462"/>
                  </a:lnTo>
                  <a:lnTo>
                    <a:pt x="660" y="1443"/>
                  </a:lnTo>
                  <a:lnTo>
                    <a:pt x="664" y="1443"/>
                  </a:lnTo>
                  <a:lnTo>
                    <a:pt x="664" y="1428"/>
                  </a:lnTo>
                  <a:lnTo>
                    <a:pt x="668" y="1428"/>
                  </a:lnTo>
                  <a:lnTo>
                    <a:pt x="672" y="1428"/>
                  </a:lnTo>
                  <a:lnTo>
                    <a:pt x="676" y="1428"/>
                  </a:lnTo>
                  <a:lnTo>
                    <a:pt x="679" y="1428"/>
                  </a:lnTo>
                  <a:lnTo>
                    <a:pt x="683" y="1428"/>
                  </a:lnTo>
                  <a:lnTo>
                    <a:pt x="687" y="1428"/>
                  </a:lnTo>
                  <a:lnTo>
                    <a:pt x="691" y="1428"/>
                  </a:lnTo>
                  <a:lnTo>
                    <a:pt x="694" y="1428"/>
                  </a:lnTo>
                  <a:lnTo>
                    <a:pt x="698" y="1428"/>
                  </a:lnTo>
                  <a:lnTo>
                    <a:pt x="702" y="1428"/>
                  </a:lnTo>
                  <a:lnTo>
                    <a:pt x="706" y="1428"/>
                  </a:lnTo>
                  <a:lnTo>
                    <a:pt x="709" y="1409"/>
                  </a:lnTo>
                  <a:lnTo>
                    <a:pt x="713" y="1409"/>
                  </a:lnTo>
                  <a:lnTo>
                    <a:pt x="717" y="1409"/>
                  </a:lnTo>
                  <a:lnTo>
                    <a:pt x="721" y="1409"/>
                  </a:lnTo>
                  <a:lnTo>
                    <a:pt x="728" y="1409"/>
                  </a:lnTo>
                  <a:lnTo>
                    <a:pt x="732" y="1409"/>
                  </a:lnTo>
                  <a:lnTo>
                    <a:pt x="732" y="1390"/>
                  </a:lnTo>
                  <a:lnTo>
                    <a:pt x="736" y="1390"/>
                  </a:lnTo>
                  <a:lnTo>
                    <a:pt x="740" y="1371"/>
                  </a:lnTo>
                  <a:lnTo>
                    <a:pt x="743" y="1371"/>
                  </a:lnTo>
                  <a:lnTo>
                    <a:pt x="747" y="1371"/>
                  </a:lnTo>
                  <a:lnTo>
                    <a:pt x="747" y="1356"/>
                  </a:lnTo>
                  <a:lnTo>
                    <a:pt x="747" y="1337"/>
                  </a:lnTo>
                  <a:lnTo>
                    <a:pt x="751" y="1337"/>
                  </a:lnTo>
                  <a:lnTo>
                    <a:pt x="758" y="1337"/>
                  </a:lnTo>
                  <a:lnTo>
                    <a:pt x="762" y="1337"/>
                  </a:lnTo>
                  <a:lnTo>
                    <a:pt x="766" y="1318"/>
                  </a:lnTo>
                  <a:lnTo>
                    <a:pt x="770" y="1318"/>
                  </a:lnTo>
                  <a:lnTo>
                    <a:pt x="774" y="1318"/>
                  </a:lnTo>
                  <a:lnTo>
                    <a:pt x="777" y="1318"/>
                  </a:lnTo>
                  <a:lnTo>
                    <a:pt x="781" y="1318"/>
                  </a:lnTo>
                  <a:lnTo>
                    <a:pt x="781" y="1299"/>
                  </a:lnTo>
                  <a:lnTo>
                    <a:pt x="785" y="1299"/>
                  </a:lnTo>
                  <a:lnTo>
                    <a:pt x="789" y="1299"/>
                  </a:lnTo>
                  <a:lnTo>
                    <a:pt x="789" y="1281"/>
                  </a:lnTo>
                  <a:lnTo>
                    <a:pt x="792" y="1281"/>
                  </a:lnTo>
                  <a:lnTo>
                    <a:pt x="796" y="1281"/>
                  </a:lnTo>
                  <a:lnTo>
                    <a:pt x="800" y="1281"/>
                  </a:lnTo>
                  <a:lnTo>
                    <a:pt x="800" y="1262"/>
                  </a:lnTo>
                  <a:lnTo>
                    <a:pt x="804" y="1262"/>
                  </a:lnTo>
                  <a:lnTo>
                    <a:pt x="808" y="1262"/>
                  </a:lnTo>
                  <a:lnTo>
                    <a:pt x="811" y="1262"/>
                  </a:lnTo>
                  <a:lnTo>
                    <a:pt x="811" y="1243"/>
                  </a:lnTo>
                  <a:lnTo>
                    <a:pt x="811" y="1224"/>
                  </a:lnTo>
                  <a:lnTo>
                    <a:pt x="815" y="1224"/>
                  </a:lnTo>
                  <a:lnTo>
                    <a:pt x="823" y="1224"/>
                  </a:lnTo>
                  <a:lnTo>
                    <a:pt x="826" y="1224"/>
                  </a:lnTo>
                  <a:lnTo>
                    <a:pt x="830" y="1224"/>
                  </a:lnTo>
                  <a:lnTo>
                    <a:pt x="834" y="1205"/>
                  </a:lnTo>
                  <a:lnTo>
                    <a:pt x="834" y="1186"/>
                  </a:lnTo>
                  <a:lnTo>
                    <a:pt x="838" y="1186"/>
                  </a:lnTo>
                  <a:lnTo>
                    <a:pt x="841" y="1186"/>
                  </a:lnTo>
                  <a:lnTo>
                    <a:pt x="845" y="1186"/>
                  </a:lnTo>
                  <a:lnTo>
                    <a:pt x="845" y="1167"/>
                  </a:lnTo>
                  <a:lnTo>
                    <a:pt x="849" y="1148"/>
                  </a:lnTo>
                  <a:lnTo>
                    <a:pt x="853" y="1130"/>
                  </a:lnTo>
                  <a:lnTo>
                    <a:pt x="857" y="1130"/>
                  </a:lnTo>
                  <a:lnTo>
                    <a:pt x="860" y="1130"/>
                  </a:lnTo>
                  <a:lnTo>
                    <a:pt x="864" y="1130"/>
                  </a:lnTo>
                  <a:lnTo>
                    <a:pt x="872" y="1130"/>
                  </a:lnTo>
                  <a:lnTo>
                    <a:pt x="879" y="1130"/>
                  </a:lnTo>
                  <a:lnTo>
                    <a:pt x="883" y="1130"/>
                  </a:lnTo>
                  <a:lnTo>
                    <a:pt x="883" y="1111"/>
                  </a:lnTo>
                  <a:lnTo>
                    <a:pt x="887" y="1111"/>
                  </a:lnTo>
                  <a:lnTo>
                    <a:pt x="890" y="1111"/>
                  </a:lnTo>
                  <a:lnTo>
                    <a:pt x="898" y="1111"/>
                  </a:lnTo>
                  <a:lnTo>
                    <a:pt x="902" y="1111"/>
                  </a:lnTo>
                  <a:lnTo>
                    <a:pt x="906" y="1111"/>
                  </a:lnTo>
                  <a:lnTo>
                    <a:pt x="906" y="1088"/>
                  </a:lnTo>
                  <a:lnTo>
                    <a:pt x="909" y="1069"/>
                  </a:lnTo>
                  <a:lnTo>
                    <a:pt x="913" y="1069"/>
                  </a:lnTo>
                  <a:lnTo>
                    <a:pt x="921" y="1069"/>
                  </a:lnTo>
                  <a:lnTo>
                    <a:pt x="924" y="1069"/>
                  </a:lnTo>
                  <a:lnTo>
                    <a:pt x="932" y="1050"/>
                  </a:lnTo>
                  <a:lnTo>
                    <a:pt x="940" y="1050"/>
                  </a:lnTo>
                  <a:lnTo>
                    <a:pt x="943" y="1050"/>
                  </a:lnTo>
                  <a:lnTo>
                    <a:pt x="951" y="1050"/>
                  </a:lnTo>
                  <a:lnTo>
                    <a:pt x="955" y="1050"/>
                  </a:lnTo>
                  <a:lnTo>
                    <a:pt x="958" y="1031"/>
                  </a:lnTo>
                  <a:lnTo>
                    <a:pt x="962" y="1031"/>
                  </a:lnTo>
                  <a:lnTo>
                    <a:pt x="966" y="1031"/>
                  </a:lnTo>
                  <a:lnTo>
                    <a:pt x="973" y="1031"/>
                  </a:lnTo>
                  <a:lnTo>
                    <a:pt x="977" y="1031"/>
                  </a:lnTo>
                  <a:lnTo>
                    <a:pt x="981" y="1031"/>
                  </a:lnTo>
                  <a:lnTo>
                    <a:pt x="981" y="1009"/>
                  </a:lnTo>
                  <a:lnTo>
                    <a:pt x="989" y="1009"/>
                  </a:lnTo>
                  <a:lnTo>
                    <a:pt x="992" y="1009"/>
                  </a:lnTo>
                  <a:lnTo>
                    <a:pt x="996" y="1009"/>
                  </a:lnTo>
                  <a:lnTo>
                    <a:pt x="1004" y="990"/>
                  </a:lnTo>
                  <a:lnTo>
                    <a:pt x="1007" y="990"/>
                  </a:lnTo>
                  <a:lnTo>
                    <a:pt x="1011" y="990"/>
                  </a:lnTo>
                  <a:lnTo>
                    <a:pt x="1019" y="990"/>
                  </a:lnTo>
                  <a:lnTo>
                    <a:pt x="1022" y="990"/>
                  </a:lnTo>
                  <a:lnTo>
                    <a:pt x="1026" y="990"/>
                  </a:lnTo>
                  <a:lnTo>
                    <a:pt x="1030" y="990"/>
                  </a:lnTo>
                  <a:lnTo>
                    <a:pt x="1034" y="990"/>
                  </a:lnTo>
                  <a:lnTo>
                    <a:pt x="1038" y="990"/>
                  </a:lnTo>
                  <a:lnTo>
                    <a:pt x="1041" y="990"/>
                  </a:lnTo>
                  <a:lnTo>
                    <a:pt x="1049" y="990"/>
                  </a:lnTo>
                  <a:lnTo>
                    <a:pt x="1053" y="990"/>
                  </a:lnTo>
                  <a:lnTo>
                    <a:pt x="1060" y="990"/>
                  </a:lnTo>
                  <a:lnTo>
                    <a:pt x="1064" y="990"/>
                  </a:lnTo>
                  <a:lnTo>
                    <a:pt x="1068" y="990"/>
                  </a:lnTo>
                  <a:lnTo>
                    <a:pt x="1071" y="990"/>
                  </a:lnTo>
                  <a:lnTo>
                    <a:pt x="1075" y="990"/>
                  </a:lnTo>
                  <a:lnTo>
                    <a:pt x="1075" y="971"/>
                  </a:lnTo>
                  <a:lnTo>
                    <a:pt x="1079" y="971"/>
                  </a:lnTo>
                  <a:lnTo>
                    <a:pt x="1083" y="971"/>
                  </a:lnTo>
                  <a:lnTo>
                    <a:pt x="1087" y="971"/>
                  </a:lnTo>
                  <a:lnTo>
                    <a:pt x="1090" y="971"/>
                  </a:lnTo>
                  <a:lnTo>
                    <a:pt x="1094" y="971"/>
                  </a:lnTo>
                  <a:lnTo>
                    <a:pt x="1094" y="948"/>
                  </a:lnTo>
                  <a:lnTo>
                    <a:pt x="1098" y="948"/>
                  </a:lnTo>
                  <a:lnTo>
                    <a:pt x="1102" y="948"/>
                  </a:lnTo>
                  <a:lnTo>
                    <a:pt x="1105" y="948"/>
                  </a:lnTo>
                  <a:lnTo>
                    <a:pt x="1109" y="948"/>
                  </a:lnTo>
                  <a:lnTo>
                    <a:pt x="1113" y="948"/>
                  </a:lnTo>
                  <a:lnTo>
                    <a:pt x="1117" y="948"/>
                  </a:lnTo>
                  <a:lnTo>
                    <a:pt x="1121" y="948"/>
                  </a:lnTo>
                  <a:lnTo>
                    <a:pt x="1124" y="948"/>
                  </a:lnTo>
                  <a:lnTo>
                    <a:pt x="1128" y="948"/>
                  </a:lnTo>
                  <a:lnTo>
                    <a:pt x="1132" y="948"/>
                  </a:lnTo>
                  <a:lnTo>
                    <a:pt x="1136" y="948"/>
                  </a:lnTo>
                  <a:lnTo>
                    <a:pt x="1139" y="948"/>
                  </a:lnTo>
                  <a:lnTo>
                    <a:pt x="1143" y="948"/>
                  </a:lnTo>
                  <a:lnTo>
                    <a:pt x="1147" y="948"/>
                  </a:lnTo>
                  <a:lnTo>
                    <a:pt x="1151" y="948"/>
                  </a:lnTo>
                  <a:lnTo>
                    <a:pt x="1154" y="948"/>
                  </a:lnTo>
                  <a:lnTo>
                    <a:pt x="1158" y="948"/>
                  </a:lnTo>
                  <a:lnTo>
                    <a:pt x="1162" y="948"/>
                  </a:lnTo>
                  <a:lnTo>
                    <a:pt x="1166" y="948"/>
                  </a:lnTo>
                  <a:lnTo>
                    <a:pt x="1170" y="948"/>
                  </a:lnTo>
                  <a:lnTo>
                    <a:pt x="1173" y="948"/>
                  </a:lnTo>
                  <a:lnTo>
                    <a:pt x="1177" y="948"/>
                  </a:lnTo>
                  <a:lnTo>
                    <a:pt x="1181" y="929"/>
                  </a:lnTo>
                  <a:lnTo>
                    <a:pt x="1188" y="929"/>
                  </a:lnTo>
                  <a:lnTo>
                    <a:pt x="1188" y="910"/>
                  </a:lnTo>
                  <a:lnTo>
                    <a:pt x="1192" y="910"/>
                  </a:lnTo>
                  <a:lnTo>
                    <a:pt x="1215" y="910"/>
                  </a:lnTo>
                  <a:lnTo>
                    <a:pt x="1215" y="888"/>
                  </a:lnTo>
                  <a:lnTo>
                    <a:pt x="1219" y="888"/>
                  </a:lnTo>
                  <a:lnTo>
                    <a:pt x="1222" y="888"/>
                  </a:lnTo>
                  <a:lnTo>
                    <a:pt x="1226" y="888"/>
                  </a:lnTo>
                  <a:lnTo>
                    <a:pt x="1230" y="888"/>
                  </a:lnTo>
                  <a:lnTo>
                    <a:pt x="1237" y="888"/>
                  </a:lnTo>
                  <a:lnTo>
                    <a:pt x="1241" y="888"/>
                  </a:lnTo>
                  <a:lnTo>
                    <a:pt x="1245" y="888"/>
                  </a:lnTo>
                  <a:lnTo>
                    <a:pt x="1249" y="888"/>
                  </a:lnTo>
                  <a:lnTo>
                    <a:pt x="1256" y="888"/>
                  </a:lnTo>
                  <a:lnTo>
                    <a:pt x="1260" y="888"/>
                  </a:lnTo>
                  <a:lnTo>
                    <a:pt x="1264" y="888"/>
                  </a:lnTo>
                  <a:lnTo>
                    <a:pt x="1264" y="869"/>
                  </a:lnTo>
                  <a:lnTo>
                    <a:pt x="1268" y="869"/>
                  </a:lnTo>
                  <a:lnTo>
                    <a:pt x="1271" y="869"/>
                  </a:lnTo>
                  <a:lnTo>
                    <a:pt x="1271" y="846"/>
                  </a:lnTo>
                  <a:lnTo>
                    <a:pt x="1275" y="846"/>
                  </a:lnTo>
                  <a:lnTo>
                    <a:pt x="1279" y="846"/>
                  </a:lnTo>
                  <a:lnTo>
                    <a:pt x="1279" y="827"/>
                  </a:lnTo>
                  <a:lnTo>
                    <a:pt x="1283" y="827"/>
                  </a:lnTo>
                  <a:lnTo>
                    <a:pt x="1286" y="827"/>
                  </a:lnTo>
                  <a:lnTo>
                    <a:pt x="1290" y="827"/>
                  </a:lnTo>
                  <a:lnTo>
                    <a:pt x="1294" y="827"/>
                  </a:lnTo>
                  <a:lnTo>
                    <a:pt x="1298" y="827"/>
                  </a:lnTo>
                  <a:lnTo>
                    <a:pt x="1302" y="827"/>
                  </a:lnTo>
                  <a:lnTo>
                    <a:pt x="1309" y="827"/>
                  </a:lnTo>
                  <a:lnTo>
                    <a:pt x="1313" y="827"/>
                  </a:lnTo>
                  <a:lnTo>
                    <a:pt x="1317" y="827"/>
                  </a:lnTo>
                  <a:lnTo>
                    <a:pt x="1320" y="827"/>
                  </a:lnTo>
                  <a:lnTo>
                    <a:pt x="1324" y="827"/>
                  </a:lnTo>
                  <a:lnTo>
                    <a:pt x="1328" y="827"/>
                  </a:lnTo>
                  <a:lnTo>
                    <a:pt x="1332" y="827"/>
                  </a:lnTo>
                  <a:lnTo>
                    <a:pt x="1335" y="827"/>
                  </a:lnTo>
                  <a:lnTo>
                    <a:pt x="1339" y="827"/>
                  </a:lnTo>
                  <a:lnTo>
                    <a:pt x="1343" y="827"/>
                  </a:lnTo>
                  <a:lnTo>
                    <a:pt x="1351" y="827"/>
                  </a:lnTo>
                  <a:lnTo>
                    <a:pt x="1354" y="827"/>
                  </a:lnTo>
                  <a:lnTo>
                    <a:pt x="1358" y="827"/>
                  </a:lnTo>
                  <a:lnTo>
                    <a:pt x="1362" y="827"/>
                  </a:lnTo>
                  <a:lnTo>
                    <a:pt x="1366" y="805"/>
                  </a:lnTo>
                  <a:lnTo>
                    <a:pt x="1369" y="805"/>
                  </a:lnTo>
                  <a:lnTo>
                    <a:pt x="1373" y="805"/>
                  </a:lnTo>
                  <a:lnTo>
                    <a:pt x="1377" y="805"/>
                  </a:lnTo>
                  <a:lnTo>
                    <a:pt x="1381" y="805"/>
                  </a:lnTo>
                  <a:lnTo>
                    <a:pt x="1385" y="805"/>
                  </a:lnTo>
                  <a:lnTo>
                    <a:pt x="1388" y="805"/>
                  </a:lnTo>
                  <a:lnTo>
                    <a:pt x="1392" y="805"/>
                  </a:lnTo>
                  <a:lnTo>
                    <a:pt x="1400" y="805"/>
                  </a:lnTo>
                  <a:lnTo>
                    <a:pt x="1403" y="805"/>
                  </a:lnTo>
                  <a:lnTo>
                    <a:pt x="1407" y="805"/>
                  </a:lnTo>
                  <a:lnTo>
                    <a:pt x="1415" y="805"/>
                  </a:lnTo>
                  <a:lnTo>
                    <a:pt x="1418" y="805"/>
                  </a:lnTo>
                  <a:lnTo>
                    <a:pt x="1422" y="805"/>
                  </a:lnTo>
                  <a:lnTo>
                    <a:pt x="1422" y="782"/>
                  </a:lnTo>
                  <a:lnTo>
                    <a:pt x="1430" y="782"/>
                  </a:lnTo>
                  <a:lnTo>
                    <a:pt x="1434" y="782"/>
                  </a:lnTo>
                  <a:lnTo>
                    <a:pt x="1437" y="782"/>
                  </a:lnTo>
                  <a:lnTo>
                    <a:pt x="1441" y="782"/>
                  </a:lnTo>
                  <a:lnTo>
                    <a:pt x="1445" y="782"/>
                  </a:lnTo>
                  <a:lnTo>
                    <a:pt x="1449" y="782"/>
                  </a:lnTo>
                  <a:lnTo>
                    <a:pt x="1452" y="782"/>
                  </a:lnTo>
                  <a:lnTo>
                    <a:pt x="1456" y="782"/>
                  </a:lnTo>
                  <a:lnTo>
                    <a:pt x="1460" y="782"/>
                  </a:lnTo>
                  <a:lnTo>
                    <a:pt x="1464" y="782"/>
                  </a:lnTo>
                  <a:lnTo>
                    <a:pt x="1467" y="782"/>
                  </a:lnTo>
                  <a:lnTo>
                    <a:pt x="1471" y="782"/>
                  </a:lnTo>
                  <a:lnTo>
                    <a:pt x="1475" y="782"/>
                  </a:lnTo>
                  <a:lnTo>
                    <a:pt x="1479" y="782"/>
                  </a:lnTo>
                  <a:lnTo>
                    <a:pt x="1483" y="782"/>
                  </a:lnTo>
                  <a:lnTo>
                    <a:pt x="1486" y="782"/>
                  </a:lnTo>
                  <a:lnTo>
                    <a:pt x="1490" y="763"/>
                  </a:lnTo>
                  <a:lnTo>
                    <a:pt x="1494" y="763"/>
                  </a:lnTo>
                  <a:lnTo>
                    <a:pt x="1498" y="763"/>
                  </a:lnTo>
                  <a:lnTo>
                    <a:pt x="1501" y="763"/>
                  </a:lnTo>
                  <a:lnTo>
                    <a:pt x="1505" y="763"/>
                  </a:lnTo>
                  <a:lnTo>
                    <a:pt x="1509" y="763"/>
                  </a:lnTo>
                  <a:lnTo>
                    <a:pt x="1513" y="763"/>
                  </a:lnTo>
                  <a:lnTo>
                    <a:pt x="1520" y="763"/>
                  </a:lnTo>
                  <a:lnTo>
                    <a:pt x="1524" y="741"/>
                  </a:lnTo>
                  <a:lnTo>
                    <a:pt x="1528" y="741"/>
                  </a:lnTo>
                  <a:lnTo>
                    <a:pt x="1532" y="741"/>
                  </a:lnTo>
                  <a:lnTo>
                    <a:pt x="1535" y="741"/>
                  </a:lnTo>
                  <a:lnTo>
                    <a:pt x="1535" y="718"/>
                  </a:lnTo>
                  <a:lnTo>
                    <a:pt x="1539" y="718"/>
                  </a:lnTo>
                  <a:lnTo>
                    <a:pt x="1543" y="718"/>
                  </a:lnTo>
                  <a:lnTo>
                    <a:pt x="1550" y="718"/>
                  </a:lnTo>
                  <a:lnTo>
                    <a:pt x="1550" y="699"/>
                  </a:lnTo>
                  <a:lnTo>
                    <a:pt x="1554" y="699"/>
                  </a:lnTo>
                  <a:lnTo>
                    <a:pt x="1558" y="699"/>
                  </a:lnTo>
                  <a:lnTo>
                    <a:pt x="1562" y="699"/>
                  </a:lnTo>
                  <a:lnTo>
                    <a:pt x="1566" y="699"/>
                  </a:lnTo>
                  <a:lnTo>
                    <a:pt x="1566" y="676"/>
                  </a:lnTo>
                  <a:lnTo>
                    <a:pt x="1569" y="676"/>
                  </a:lnTo>
                  <a:lnTo>
                    <a:pt x="1573" y="676"/>
                  </a:lnTo>
                  <a:lnTo>
                    <a:pt x="1577" y="676"/>
                  </a:lnTo>
                  <a:lnTo>
                    <a:pt x="1581" y="676"/>
                  </a:lnTo>
                  <a:lnTo>
                    <a:pt x="1584" y="676"/>
                  </a:lnTo>
                  <a:lnTo>
                    <a:pt x="1588" y="676"/>
                  </a:lnTo>
                  <a:lnTo>
                    <a:pt x="1592" y="676"/>
                  </a:lnTo>
                  <a:lnTo>
                    <a:pt x="1596" y="676"/>
                  </a:lnTo>
                  <a:lnTo>
                    <a:pt x="1599" y="676"/>
                  </a:lnTo>
                  <a:lnTo>
                    <a:pt x="1603" y="676"/>
                  </a:lnTo>
                  <a:lnTo>
                    <a:pt x="1607" y="676"/>
                  </a:lnTo>
                  <a:lnTo>
                    <a:pt x="1611" y="676"/>
                  </a:lnTo>
                  <a:lnTo>
                    <a:pt x="1611" y="654"/>
                  </a:lnTo>
                  <a:lnTo>
                    <a:pt x="1615" y="654"/>
                  </a:lnTo>
                  <a:lnTo>
                    <a:pt x="1615" y="631"/>
                  </a:lnTo>
                  <a:lnTo>
                    <a:pt x="1618" y="631"/>
                  </a:lnTo>
                  <a:lnTo>
                    <a:pt x="1622" y="631"/>
                  </a:lnTo>
                  <a:lnTo>
                    <a:pt x="1622" y="608"/>
                  </a:lnTo>
                  <a:lnTo>
                    <a:pt x="1622" y="586"/>
                  </a:lnTo>
                  <a:lnTo>
                    <a:pt x="1626" y="586"/>
                  </a:lnTo>
                  <a:lnTo>
                    <a:pt x="1626" y="563"/>
                  </a:lnTo>
                  <a:lnTo>
                    <a:pt x="1630" y="563"/>
                  </a:lnTo>
                  <a:lnTo>
                    <a:pt x="1630" y="540"/>
                  </a:lnTo>
                  <a:lnTo>
                    <a:pt x="1633" y="540"/>
                  </a:lnTo>
                  <a:lnTo>
                    <a:pt x="1637" y="540"/>
                  </a:lnTo>
                  <a:lnTo>
                    <a:pt x="1641" y="540"/>
                  </a:lnTo>
                  <a:lnTo>
                    <a:pt x="1645" y="540"/>
                  </a:lnTo>
                  <a:lnTo>
                    <a:pt x="1652" y="540"/>
                  </a:lnTo>
                  <a:lnTo>
                    <a:pt x="1656" y="540"/>
                  </a:lnTo>
                  <a:lnTo>
                    <a:pt x="1660" y="540"/>
                  </a:lnTo>
                  <a:lnTo>
                    <a:pt x="1664" y="518"/>
                  </a:lnTo>
                  <a:lnTo>
                    <a:pt x="1667" y="518"/>
                  </a:lnTo>
                  <a:lnTo>
                    <a:pt x="1671" y="518"/>
                  </a:lnTo>
                  <a:lnTo>
                    <a:pt x="1675" y="518"/>
                  </a:lnTo>
                  <a:lnTo>
                    <a:pt x="1679" y="518"/>
                  </a:lnTo>
                  <a:lnTo>
                    <a:pt x="1682" y="518"/>
                  </a:lnTo>
                  <a:lnTo>
                    <a:pt x="1686" y="518"/>
                  </a:lnTo>
                  <a:lnTo>
                    <a:pt x="1686" y="491"/>
                  </a:lnTo>
                  <a:lnTo>
                    <a:pt x="1686" y="469"/>
                  </a:lnTo>
                  <a:lnTo>
                    <a:pt x="1690" y="469"/>
                  </a:lnTo>
                  <a:lnTo>
                    <a:pt x="1694" y="446"/>
                  </a:lnTo>
                  <a:lnTo>
                    <a:pt x="1698" y="446"/>
                  </a:lnTo>
                  <a:lnTo>
                    <a:pt x="1701" y="446"/>
                  </a:lnTo>
                  <a:lnTo>
                    <a:pt x="1705" y="446"/>
                  </a:lnTo>
                  <a:lnTo>
                    <a:pt x="1709" y="446"/>
                  </a:lnTo>
                  <a:lnTo>
                    <a:pt x="1713" y="446"/>
                  </a:lnTo>
                  <a:lnTo>
                    <a:pt x="1716" y="446"/>
                  </a:lnTo>
                  <a:lnTo>
                    <a:pt x="1720" y="446"/>
                  </a:lnTo>
                  <a:lnTo>
                    <a:pt x="1720" y="420"/>
                  </a:lnTo>
                  <a:lnTo>
                    <a:pt x="1724" y="420"/>
                  </a:lnTo>
                  <a:lnTo>
                    <a:pt x="1728" y="420"/>
                  </a:lnTo>
                  <a:lnTo>
                    <a:pt x="1731" y="420"/>
                  </a:lnTo>
                  <a:lnTo>
                    <a:pt x="1735" y="420"/>
                  </a:lnTo>
                  <a:lnTo>
                    <a:pt x="1739" y="420"/>
                  </a:lnTo>
                  <a:lnTo>
                    <a:pt x="1743" y="420"/>
                  </a:lnTo>
                  <a:lnTo>
                    <a:pt x="1747" y="397"/>
                  </a:lnTo>
                  <a:lnTo>
                    <a:pt x="1750" y="397"/>
                  </a:lnTo>
                  <a:lnTo>
                    <a:pt x="1754" y="397"/>
                  </a:lnTo>
                  <a:lnTo>
                    <a:pt x="1758" y="397"/>
                  </a:lnTo>
                  <a:lnTo>
                    <a:pt x="1758" y="370"/>
                  </a:lnTo>
                  <a:lnTo>
                    <a:pt x="1762" y="370"/>
                  </a:lnTo>
                  <a:lnTo>
                    <a:pt x="1765" y="370"/>
                  </a:lnTo>
                  <a:lnTo>
                    <a:pt x="1769" y="370"/>
                  </a:lnTo>
                  <a:lnTo>
                    <a:pt x="1773" y="370"/>
                  </a:lnTo>
                  <a:lnTo>
                    <a:pt x="1777" y="370"/>
                  </a:lnTo>
                  <a:lnTo>
                    <a:pt x="1784" y="370"/>
                  </a:lnTo>
                  <a:lnTo>
                    <a:pt x="1788" y="370"/>
                  </a:lnTo>
                  <a:lnTo>
                    <a:pt x="1792" y="370"/>
                  </a:lnTo>
                  <a:lnTo>
                    <a:pt x="1796" y="370"/>
                  </a:lnTo>
                  <a:lnTo>
                    <a:pt x="1799" y="370"/>
                  </a:lnTo>
                  <a:lnTo>
                    <a:pt x="1803" y="370"/>
                  </a:lnTo>
                  <a:lnTo>
                    <a:pt x="1807" y="370"/>
                  </a:lnTo>
                  <a:lnTo>
                    <a:pt x="1811" y="370"/>
                  </a:lnTo>
                  <a:lnTo>
                    <a:pt x="1814" y="370"/>
                  </a:lnTo>
                  <a:lnTo>
                    <a:pt x="1818" y="370"/>
                  </a:lnTo>
                  <a:lnTo>
                    <a:pt x="1822" y="370"/>
                  </a:lnTo>
                  <a:lnTo>
                    <a:pt x="1826" y="370"/>
                  </a:lnTo>
                  <a:lnTo>
                    <a:pt x="1826" y="344"/>
                  </a:lnTo>
                  <a:lnTo>
                    <a:pt x="1830" y="318"/>
                  </a:lnTo>
                  <a:lnTo>
                    <a:pt x="1833" y="291"/>
                  </a:lnTo>
                  <a:lnTo>
                    <a:pt x="1837" y="291"/>
                  </a:lnTo>
                  <a:lnTo>
                    <a:pt x="1841" y="291"/>
                  </a:lnTo>
                  <a:lnTo>
                    <a:pt x="1845" y="291"/>
                  </a:lnTo>
                  <a:lnTo>
                    <a:pt x="1848" y="291"/>
                  </a:lnTo>
                  <a:lnTo>
                    <a:pt x="1852" y="291"/>
                  </a:lnTo>
                  <a:lnTo>
                    <a:pt x="1856" y="291"/>
                  </a:lnTo>
                  <a:lnTo>
                    <a:pt x="1860" y="291"/>
                  </a:lnTo>
                  <a:lnTo>
                    <a:pt x="1863" y="265"/>
                  </a:lnTo>
                  <a:lnTo>
                    <a:pt x="1867" y="265"/>
                  </a:lnTo>
                  <a:lnTo>
                    <a:pt x="1867" y="234"/>
                  </a:lnTo>
                  <a:lnTo>
                    <a:pt x="1875" y="234"/>
                  </a:lnTo>
                  <a:lnTo>
                    <a:pt x="1879" y="234"/>
                  </a:lnTo>
                  <a:lnTo>
                    <a:pt x="1882" y="234"/>
                  </a:lnTo>
                  <a:lnTo>
                    <a:pt x="1886" y="234"/>
                  </a:lnTo>
                  <a:lnTo>
                    <a:pt x="1890" y="234"/>
                  </a:lnTo>
                  <a:lnTo>
                    <a:pt x="1897" y="234"/>
                  </a:lnTo>
                  <a:lnTo>
                    <a:pt x="1897" y="208"/>
                  </a:lnTo>
                  <a:lnTo>
                    <a:pt x="1901" y="208"/>
                  </a:lnTo>
                  <a:lnTo>
                    <a:pt x="1905" y="208"/>
                  </a:lnTo>
                  <a:lnTo>
                    <a:pt x="1909" y="208"/>
                  </a:lnTo>
                  <a:lnTo>
                    <a:pt x="1912" y="208"/>
                  </a:lnTo>
                  <a:lnTo>
                    <a:pt x="1916" y="208"/>
                  </a:lnTo>
                  <a:lnTo>
                    <a:pt x="1920" y="208"/>
                  </a:lnTo>
                  <a:lnTo>
                    <a:pt x="1924" y="208"/>
                  </a:lnTo>
                  <a:lnTo>
                    <a:pt x="1928" y="208"/>
                  </a:lnTo>
                  <a:lnTo>
                    <a:pt x="1931" y="174"/>
                  </a:lnTo>
                  <a:lnTo>
                    <a:pt x="1935" y="174"/>
                  </a:lnTo>
                  <a:lnTo>
                    <a:pt x="1935" y="140"/>
                  </a:lnTo>
                  <a:lnTo>
                    <a:pt x="1935" y="102"/>
                  </a:lnTo>
                  <a:lnTo>
                    <a:pt x="1939" y="102"/>
                  </a:lnTo>
                  <a:lnTo>
                    <a:pt x="1943" y="102"/>
                  </a:lnTo>
                  <a:lnTo>
                    <a:pt x="1943" y="0"/>
                  </a:lnTo>
                </a:path>
              </a:pathLst>
            </a:custGeom>
            <a:noFill/>
            <a:ln w="38160">
              <a:solidFill>
                <a:srgbClr val="000000"/>
              </a:solidFill>
              <a:prstDash val="sysDot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1157400" y="2082960"/>
              <a:ext cx="3144600" cy="3165480"/>
            </a:xfrm>
            <a:custGeom>
              <a:avLst/>
              <a:gdLst/>
              <a:ahLst/>
              <a:rect l="l" t="t" r="r" b="b"/>
              <a:pathLst>
                <a:path w="1924" h="1945">
                  <a:moveTo>
                    <a:pt x="0" y="1945"/>
                  </a:moveTo>
                  <a:lnTo>
                    <a:pt x="0" y="1847"/>
                  </a:lnTo>
                  <a:lnTo>
                    <a:pt x="0" y="1809"/>
                  </a:lnTo>
                  <a:lnTo>
                    <a:pt x="0" y="1775"/>
                  </a:lnTo>
                  <a:lnTo>
                    <a:pt x="4" y="1775"/>
                  </a:lnTo>
                  <a:lnTo>
                    <a:pt x="8" y="1775"/>
                  </a:lnTo>
                  <a:lnTo>
                    <a:pt x="12" y="1775"/>
                  </a:lnTo>
                  <a:lnTo>
                    <a:pt x="12" y="1741"/>
                  </a:lnTo>
                  <a:lnTo>
                    <a:pt x="16" y="1741"/>
                  </a:lnTo>
                  <a:lnTo>
                    <a:pt x="19" y="1741"/>
                  </a:lnTo>
                  <a:lnTo>
                    <a:pt x="23" y="1741"/>
                  </a:lnTo>
                  <a:lnTo>
                    <a:pt x="23" y="1715"/>
                  </a:lnTo>
                  <a:lnTo>
                    <a:pt x="27" y="1715"/>
                  </a:lnTo>
                  <a:lnTo>
                    <a:pt x="27" y="1685"/>
                  </a:lnTo>
                  <a:lnTo>
                    <a:pt x="27" y="1658"/>
                  </a:lnTo>
                  <a:lnTo>
                    <a:pt x="31" y="1658"/>
                  </a:lnTo>
                  <a:lnTo>
                    <a:pt x="34" y="1658"/>
                  </a:lnTo>
                  <a:lnTo>
                    <a:pt x="38" y="1658"/>
                  </a:lnTo>
                  <a:lnTo>
                    <a:pt x="42" y="1658"/>
                  </a:lnTo>
                  <a:lnTo>
                    <a:pt x="46" y="1658"/>
                  </a:lnTo>
                  <a:lnTo>
                    <a:pt x="49" y="1658"/>
                  </a:lnTo>
                  <a:lnTo>
                    <a:pt x="49" y="1632"/>
                  </a:lnTo>
                  <a:lnTo>
                    <a:pt x="53" y="1632"/>
                  </a:lnTo>
                  <a:lnTo>
                    <a:pt x="57" y="1632"/>
                  </a:lnTo>
                  <a:lnTo>
                    <a:pt x="61" y="1632"/>
                  </a:lnTo>
                  <a:lnTo>
                    <a:pt x="65" y="1632"/>
                  </a:lnTo>
                  <a:lnTo>
                    <a:pt x="68" y="1632"/>
                  </a:lnTo>
                  <a:lnTo>
                    <a:pt x="72" y="1632"/>
                  </a:lnTo>
                  <a:lnTo>
                    <a:pt x="76" y="1632"/>
                  </a:lnTo>
                  <a:lnTo>
                    <a:pt x="80" y="1632"/>
                  </a:lnTo>
                  <a:lnTo>
                    <a:pt x="80" y="1605"/>
                  </a:lnTo>
                  <a:lnTo>
                    <a:pt x="80" y="1579"/>
                  </a:lnTo>
                  <a:lnTo>
                    <a:pt x="80" y="1553"/>
                  </a:lnTo>
                  <a:lnTo>
                    <a:pt x="83" y="1553"/>
                  </a:lnTo>
                  <a:lnTo>
                    <a:pt x="83" y="1530"/>
                  </a:lnTo>
                  <a:lnTo>
                    <a:pt x="87" y="1530"/>
                  </a:lnTo>
                  <a:lnTo>
                    <a:pt x="91" y="1530"/>
                  </a:lnTo>
                  <a:lnTo>
                    <a:pt x="95" y="1530"/>
                  </a:lnTo>
                  <a:lnTo>
                    <a:pt x="99" y="1530"/>
                  </a:lnTo>
                  <a:lnTo>
                    <a:pt x="102" y="1530"/>
                  </a:lnTo>
                  <a:lnTo>
                    <a:pt x="106" y="1530"/>
                  </a:lnTo>
                  <a:lnTo>
                    <a:pt x="110" y="1530"/>
                  </a:lnTo>
                  <a:lnTo>
                    <a:pt x="114" y="1503"/>
                  </a:lnTo>
                  <a:lnTo>
                    <a:pt x="117" y="1503"/>
                  </a:lnTo>
                  <a:lnTo>
                    <a:pt x="121" y="1503"/>
                  </a:lnTo>
                  <a:lnTo>
                    <a:pt x="121" y="1481"/>
                  </a:lnTo>
                  <a:lnTo>
                    <a:pt x="125" y="1481"/>
                  </a:lnTo>
                  <a:lnTo>
                    <a:pt x="125" y="1458"/>
                  </a:lnTo>
                  <a:lnTo>
                    <a:pt x="129" y="1458"/>
                  </a:lnTo>
                  <a:lnTo>
                    <a:pt x="132" y="1458"/>
                  </a:lnTo>
                  <a:lnTo>
                    <a:pt x="136" y="1458"/>
                  </a:lnTo>
                  <a:lnTo>
                    <a:pt x="140" y="1458"/>
                  </a:lnTo>
                  <a:lnTo>
                    <a:pt x="144" y="1458"/>
                  </a:lnTo>
                  <a:lnTo>
                    <a:pt x="148" y="1458"/>
                  </a:lnTo>
                  <a:lnTo>
                    <a:pt x="148" y="1432"/>
                  </a:lnTo>
                  <a:lnTo>
                    <a:pt x="151" y="1432"/>
                  </a:lnTo>
                  <a:lnTo>
                    <a:pt x="151" y="1409"/>
                  </a:lnTo>
                  <a:lnTo>
                    <a:pt x="151" y="1386"/>
                  </a:lnTo>
                  <a:lnTo>
                    <a:pt x="163" y="1386"/>
                  </a:lnTo>
                  <a:lnTo>
                    <a:pt x="163" y="1364"/>
                  </a:lnTo>
                  <a:lnTo>
                    <a:pt x="166" y="1364"/>
                  </a:lnTo>
                  <a:lnTo>
                    <a:pt x="170" y="1364"/>
                  </a:lnTo>
                  <a:lnTo>
                    <a:pt x="174" y="1364"/>
                  </a:lnTo>
                  <a:lnTo>
                    <a:pt x="181" y="1364"/>
                  </a:lnTo>
                  <a:lnTo>
                    <a:pt x="185" y="1364"/>
                  </a:lnTo>
                  <a:lnTo>
                    <a:pt x="189" y="1364"/>
                  </a:lnTo>
                  <a:lnTo>
                    <a:pt x="189" y="1341"/>
                  </a:lnTo>
                  <a:lnTo>
                    <a:pt x="193" y="1341"/>
                  </a:lnTo>
                  <a:lnTo>
                    <a:pt x="197" y="1341"/>
                  </a:lnTo>
                  <a:lnTo>
                    <a:pt x="200" y="1341"/>
                  </a:lnTo>
                  <a:lnTo>
                    <a:pt x="204" y="1341"/>
                  </a:lnTo>
                  <a:lnTo>
                    <a:pt x="208" y="1341"/>
                  </a:lnTo>
                  <a:lnTo>
                    <a:pt x="212" y="1318"/>
                  </a:lnTo>
                  <a:lnTo>
                    <a:pt x="215" y="1318"/>
                  </a:lnTo>
                  <a:lnTo>
                    <a:pt x="219" y="1296"/>
                  </a:lnTo>
                  <a:lnTo>
                    <a:pt x="223" y="1296"/>
                  </a:lnTo>
                  <a:lnTo>
                    <a:pt x="227" y="1296"/>
                  </a:lnTo>
                  <a:lnTo>
                    <a:pt x="231" y="1296"/>
                  </a:lnTo>
                  <a:lnTo>
                    <a:pt x="234" y="1273"/>
                  </a:lnTo>
                  <a:lnTo>
                    <a:pt x="238" y="1273"/>
                  </a:lnTo>
                  <a:lnTo>
                    <a:pt x="242" y="1273"/>
                  </a:lnTo>
                  <a:lnTo>
                    <a:pt x="246" y="1273"/>
                  </a:lnTo>
                  <a:lnTo>
                    <a:pt x="253" y="1273"/>
                  </a:lnTo>
                  <a:lnTo>
                    <a:pt x="257" y="1273"/>
                  </a:lnTo>
                  <a:lnTo>
                    <a:pt x="261" y="1273"/>
                  </a:lnTo>
                  <a:lnTo>
                    <a:pt x="268" y="1273"/>
                  </a:lnTo>
                  <a:lnTo>
                    <a:pt x="272" y="1273"/>
                  </a:lnTo>
                  <a:lnTo>
                    <a:pt x="272" y="1250"/>
                  </a:lnTo>
                  <a:lnTo>
                    <a:pt x="272" y="1231"/>
                  </a:lnTo>
                  <a:lnTo>
                    <a:pt x="276" y="1231"/>
                  </a:lnTo>
                  <a:lnTo>
                    <a:pt x="280" y="1231"/>
                  </a:lnTo>
                  <a:lnTo>
                    <a:pt x="280" y="1209"/>
                  </a:lnTo>
                  <a:lnTo>
                    <a:pt x="283" y="1209"/>
                  </a:lnTo>
                  <a:lnTo>
                    <a:pt x="287" y="1209"/>
                  </a:lnTo>
                  <a:lnTo>
                    <a:pt x="291" y="1209"/>
                  </a:lnTo>
                  <a:lnTo>
                    <a:pt x="295" y="1209"/>
                  </a:lnTo>
                  <a:lnTo>
                    <a:pt x="298" y="1209"/>
                  </a:lnTo>
                  <a:lnTo>
                    <a:pt x="302" y="1209"/>
                  </a:lnTo>
                  <a:lnTo>
                    <a:pt x="306" y="1209"/>
                  </a:lnTo>
                  <a:lnTo>
                    <a:pt x="310" y="1186"/>
                  </a:lnTo>
                  <a:lnTo>
                    <a:pt x="313" y="1186"/>
                  </a:lnTo>
                  <a:lnTo>
                    <a:pt x="317" y="1186"/>
                  </a:lnTo>
                  <a:lnTo>
                    <a:pt x="321" y="1186"/>
                  </a:lnTo>
                  <a:lnTo>
                    <a:pt x="325" y="1186"/>
                  </a:lnTo>
                  <a:lnTo>
                    <a:pt x="329" y="1186"/>
                  </a:lnTo>
                  <a:lnTo>
                    <a:pt x="329" y="1167"/>
                  </a:lnTo>
                  <a:lnTo>
                    <a:pt x="332" y="1167"/>
                  </a:lnTo>
                  <a:lnTo>
                    <a:pt x="336" y="1167"/>
                  </a:lnTo>
                  <a:lnTo>
                    <a:pt x="336" y="1145"/>
                  </a:lnTo>
                  <a:lnTo>
                    <a:pt x="344" y="1145"/>
                  </a:lnTo>
                  <a:lnTo>
                    <a:pt x="347" y="1145"/>
                  </a:lnTo>
                  <a:lnTo>
                    <a:pt x="355" y="1145"/>
                  </a:lnTo>
                  <a:lnTo>
                    <a:pt x="359" y="1122"/>
                  </a:lnTo>
                  <a:lnTo>
                    <a:pt x="359" y="1103"/>
                  </a:lnTo>
                  <a:lnTo>
                    <a:pt x="362" y="1103"/>
                  </a:lnTo>
                  <a:lnTo>
                    <a:pt x="366" y="1103"/>
                  </a:lnTo>
                  <a:lnTo>
                    <a:pt x="370" y="1103"/>
                  </a:lnTo>
                  <a:lnTo>
                    <a:pt x="374" y="1103"/>
                  </a:lnTo>
                  <a:lnTo>
                    <a:pt x="381" y="1103"/>
                  </a:lnTo>
                  <a:lnTo>
                    <a:pt x="385" y="1103"/>
                  </a:lnTo>
                  <a:lnTo>
                    <a:pt x="389" y="1103"/>
                  </a:lnTo>
                  <a:lnTo>
                    <a:pt x="393" y="1080"/>
                  </a:lnTo>
                  <a:lnTo>
                    <a:pt x="396" y="1062"/>
                  </a:lnTo>
                  <a:lnTo>
                    <a:pt x="396" y="1039"/>
                  </a:lnTo>
                  <a:lnTo>
                    <a:pt x="400" y="1039"/>
                  </a:lnTo>
                  <a:lnTo>
                    <a:pt x="404" y="1039"/>
                  </a:lnTo>
                  <a:lnTo>
                    <a:pt x="408" y="1039"/>
                  </a:lnTo>
                  <a:lnTo>
                    <a:pt x="412" y="1039"/>
                  </a:lnTo>
                  <a:lnTo>
                    <a:pt x="415" y="1039"/>
                  </a:lnTo>
                  <a:lnTo>
                    <a:pt x="419" y="1039"/>
                  </a:lnTo>
                  <a:lnTo>
                    <a:pt x="423" y="1039"/>
                  </a:lnTo>
                  <a:lnTo>
                    <a:pt x="427" y="1039"/>
                  </a:lnTo>
                  <a:lnTo>
                    <a:pt x="430" y="1020"/>
                  </a:lnTo>
                  <a:lnTo>
                    <a:pt x="434" y="1020"/>
                  </a:lnTo>
                  <a:lnTo>
                    <a:pt x="434" y="1001"/>
                  </a:lnTo>
                  <a:lnTo>
                    <a:pt x="438" y="1001"/>
                  </a:lnTo>
                  <a:lnTo>
                    <a:pt x="442" y="1001"/>
                  </a:lnTo>
                  <a:lnTo>
                    <a:pt x="449" y="1001"/>
                  </a:lnTo>
                  <a:lnTo>
                    <a:pt x="457" y="1001"/>
                  </a:lnTo>
                  <a:lnTo>
                    <a:pt x="461" y="978"/>
                  </a:lnTo>
                  <a:lnTo>
                    <a:pt x="464" y="978"/>
                  </a:lnTo>
                  <a:lnTo>
                    <a:pt x="468" y="978"/>
                  </a:lnTo>
                  <a:lnTo>
                    <a:pt x="472" y="978"/>
                  </a:lnTo>
                  <a:lnTo>
                    <a:pt x="479" y="978"/>
                  </a:lnTo>
                  <a:lnTo>
                    <a:pt x="479" y="960"/>
                  </a:lnTo>
                  <a:lnTo>
                    <a:pt x="483" y="960"/>
                  </a:lnTo>
                  <a:lnTo>
                    <a:pt x="483" y="941"/>
                  </a:lnTo>
                  <a:lnTo>
                    <a:pt x="487" y="941"/>
                  </a:lnTo>
                  <a:lnTo>
                    <a:pt x="491" y="941"/>
                  </a:lnTo>
                  <a:lnTo>
                    <a:pt x="494" y="941"/>
                  </a:lnTo>
                  <a:lnTo>
                    <a:pt x="498" y="941"/>
                  </a:lnTo>
                  <a:lnTo>
                    <a:pt x="502" y="941"/>
                  </a:lnTo>
                  <a:lnTo>
                    <a:pt x="506" y="941"/>
                  </a:lnTo>
                  <a:lnTo>
                    <a:pt x="510" y="941"/>
                  </a:lnTo>
                  <a:lnTo>
                    <a:pt x="513" y="941"/>
                  </a:lnTo>
                  <a:lnTo>
                    <a:pt x="517" y="941"/>
                  </a:lnTo>
                  <a:lnTo>
                    <a:pt x="521" y="918"/>
                  </a:lnTo>
                  <a:lnTo>
                    <a:pt x="525" y="918"/>
                  </a:lnTo>
                  <a:lnTo>
                    <a:pt x="528" y="918"/>
                  </a:lnTo>
                  <a:lnTo>
                    <a:pt x="532" y="918"/>
                  </a:lnTo>
                  <a:lnTo>
                    <a:pt x="536" y="918"/>
                  </a:lnTo>
                  <a:lnTo>
                    <a:pt x="540" y="918"/>
                  </a:lnTo>
                  <a:lnTo>
                    <a:pt x="544" y="918"/>
                  </a:lnTo>
                  <a:lnTo>
                    <a:pt x="544" y="899"/>
                  </a:lnTo>
                  <a:lnTo>
                    <a:pt x="547" y="899"/>
                  </a:lnTo>
                  <a:lnTo>
                    <a:pt x="551" y="880"/>
                  </a:lnTo>
                  <a:lnTo>
                    <a:pt x="555" y="880"/>
                  </a:lnTo>
                  <a:lnTo>
                    <a:pt x="559" y="861"/>
                  </a:lnTo>
                  <a:lnTo>
                    <a:pt x="559" y="839"/>
                  </a:lnTo>
                  <a:lnTo>
                    <a:pt x="562" y="839"/>
                  </a:lnTo>
                  <a:lnTo>
                    <a:pt x="570" y="839"/>
                  </a:lnTo>
                  <a:lnTo>
                    <a:pt x="574" y="820"/>
                  </a:lnTo>
                  <a:lnTo>
                    <a:pt x="577" y="820"/>
                  </a:lnTo>
                  <a:lnTo>
                    <a:pt x="581" y="820"/>
                  </a:lnTo>
                  <a:lnTo>
                    <a:pt x="585" y="820"/>
                  </a:lnTo>
                  <a:lnTo>
                    <a:pt x="589" y="820"/>
                  </a:lnTo>
                  <a:lnTo>
                    <a:pt x="589" y="801"/>
                  </a:lnTo>
                  <a:lnTo>
                    <a:pt x="593" y="801"/>
                  </a:lnTo>
                  <a:lnTo>
                    <a:pt x="596" y="801"/>
                  </a:lnTo>
                  <a:lnTo>
                    <a:pt x="596" y="782"/>
                  </a:lnTo>
                  <a:lnTo>
                    <a:pt x="600" y="782"/>
                  </a:lnTo>
                  <a:lnTo>
                    <a:pt x="604" y="782"/>
                  </a:lnTo>
                  <a:lnTo>
                    <a:pt x="608" y="782"/>
                  </a:lnTo>
                  <a:lnTo>
                    <a:pt x="608" y="763"/>
                  </a:lnTo>
                  <a:lnTo>
                    <a:pt x="611" y="763"/>
                  </a:lnTo>
                  <a:lnTo>
                    <a:pt x="615" y="763"/>
                  </a:lnTo>
                  <a:lnTo>
                    <a:pt x="619" y="763"/>
                  </a:lnTo>
                  <a:lnTo>
                    <a:pt x="619" y="744"/>
                  </a:lnTo>
                  <a:lnTo>
                    <a:pt x="619" y="725"/>
                  </a:lnTo>
                  <a:lnTo>
                    <a:pt x="623" y="725"/>
                  </a:lnTo>
                  <a:lnTo>
                    <a:pt x="626" y="725"/>
                  </a:lnTo>
                  <a:lnTo>
                    <a:pt x="630" y="725"/>
                  </a:lnTo>
                  <a:lnTo>
                    <a:pt x="634" y="725"/>
                  </a:lnTo>
                  <a:lnTo>
                    <a:pt x="642" y="707"/>
                  </a:lnTo>
                  <a:lnTo>
                    <a:pt x="642" y="688"/>
                  </a:lnTo>
                  <a:lnTo>
                    <a:pt x="645" y="688"/>
                  </a:lnTo>
                  <a:lnTo>
                    <a:pt x="649" y="688"/>
                  </a:lnTo>
                  <a:lnTo>
                    <a:pt x="649" y="669"/>
                  </a:lnTo>
                  <a:lnTo>
                    <a:pt x="653" y="650"/>
                  </a:lnTo>
                  <a:lnTo>
                    <a:pt x="657" y="631"/>
                  </a:lnTo>
                  <a:lnTo>
                    <a:pt x="660" y="631"/>
                  </a:lnTo>
                  <a:lnTo>
                    <a:pt x="664" y="631"/>
                  </a:lnTo>
                  <a:lnTo>
                    <a:pt x="668" y="631"/>
                  </a:lnTo>
                  <a:lnTo>
                    <a:pt x="676" y="631"/>
                  </a:lnTo>
                  <a:lnTo>
                    <a:pt x="679" y="631"/>
                  </a:lnTo>
                  <a:lnTo>
                    <a:pt x="683" y="631"/>
                  </a:lnTo>
                  <a:lnTo>
                    <a:pt x="683" y="612"/>
                  </a:lnTo>
                  <a:lnTo>
                    <a:pt x="687" y="612"/>
                  </a:lnTo>
                  <a:lnTo>
                    <a:pt x="691" y="612"/>
                  </a:lnTo>
                  <a:lnTo>
                    <a:pt x="694" y="612"/>
                  </a:lnTo>
                  <a:lnTo>
                    <a:pt x="702" y="612"/>
                  </a:lnTo>
                  <a:lnTo>
                    <a:pt x="706" y="612"/>
                  </a:lnTo>
                  <a:lnTo>
                    <a:pt x="709" y="593"/>
                  </a:lnTo>
                  <a:lnTo>
                    <a:pt x="713" y="578"/>
                  </a:lnTo>
                  <a:lnTo>
                    <a:pt x="717" y="578"/>
                  </a:lnTo>
                  <a:lnTo>
                    <a:pt x="721" y="578"/>
                  </a:lnTo>
                  <a:lnTo>
                    <a:pt x="725" y="578"/>
                  </a:lnTo>
                  <a:lnTo>
                    <a:pt x="732" y="559"/>
                  </a:lnTo>
                  <a:lnTo>
                    <a:pt x="736" y="559"/>
                  </a:lnTo>
                  <a:lnTo>
                    <a:pt x="740" y="559"/>
                  </a:lnTo>
                  <a:lnTo>
                    <a:pt x="743" y="559"/>
                  </a:lnTo>
                  <a:lnTo>
                    <a:pt x="751" y="559"/>
                  </a:lnTo>
                  <a:lnTo>
                    <a:pt x="758" y="559"/>
                  </a:lnTo>
                  <a:lnTo>
                    <a:pt x="762" y="540"/>
                  </a:lnTo>
                  <a:lnTo>
                    <a:pt x="766" y="540"/>
                  </a:lnTo>
                  <a:lnTo>
                    <a:pt x="774" y="540"/>
                  </a:lnTo>
                  <a:lnTo>
                    <a:pt x="777" y="540"/>
                  </a:lnTo>
                  <a:lnTo>
                    <a:pt x="781" y="540"/>
                  </a:lnTo>
                  <a:lnTo>
                    <a:pt x="781" y="521"/>
                  </a:lnTo>
                  <a:lnTo>
                    <a:pt x="789" y="521"/>
                  </a:lnTo>
                  <a:lnTo>
                    <a:pt x="792" y="521"/>
                  </a:lnTo>
                  <a:lnTo>
                    <a:pt x="796" y="521"/>
                  </a:lnTo>
                  <a:lnTo>
                    <a:pt x="804" y="506"/>
                  </a:lnTo>
                  <a:lnTo>
                    <a:pt x="808" y="506"/>
                  </a:lnTo>
                  <a:lnTo>
                    <a:pt x="811" y="506"/>
                  </a:lnTo>
                  <a:lnTo>
                    <a:pt x="819" y="506"/>
                  </a:lnTo>
                  <a:lnTo>
                    <a:pt x="823" y="506"/>
                  </a:lnTo>
                  <a:lnTo>
                    <a:pt x="826" y="506"/>
                  </a:lnTo>
                  <a:lnTo>
                    <a:pt x="830" y="506"/>
                  </a:lnTo>
                  <a:lnTo>
                    <a:pt x="834" y="506"/>
                  </a:lnTo>
                  <a:lnTo>
                    <a:pt x="838" y="506"/>
                  </a:lnTo>
                  <a:lnTo>
                    <a:pt x="841" y="506"/>
                  </a:lnTo>
                  <a:lnTo>
                    <a:pt x="845" y="506"/>
                  </a:lnTo>
                  <a:lnTo>
                    <a:pt x="849" y="506"/>
                  </a:lnTo>
                  <a:lnTo>
                    <a:pt x="853" y="506"/>
                  </a:lnTo>
                  <a:lnTo>
                    <a:pt x="860" y="506"/>
                  </a:lnTo>
                  <a:lnTo>
                    <a:pt x="864" y="506"/>
                  </a:lnTo>
                  <a:lnTo>
                    <a:pt x="868" y="506"/>
                  </a:lnTo>
                  <a:lnTo>
                    <a:pt x="872" y="506"/>
                  </a:lnTo>
                  <a:lnTo>
                    <a:pt x="875" y="506"/>
                  </a:lnTo>
                  <a:lnTo>
                    <a:pt x="875" y="487"/>
                  </a:lnTo>
                  <a:lnTo>
                    <a:pt x="879" y="487"/>
                  </a:lnTo>
                  <a:lnTo>
                    <a:pt x="883" y="487"/>
                  </a:lnTo>
                  <a:lnTo>
                    <a:pt x="887" y="487"/>
                  </a:lnTo>
                  <a:lnTo>
                    <a:pt x="890" y="487"/>
                  </a:lnTo>
                  <a:lnTo>
                    <a:pt x="894" y="469"/>
                  </a:lnTo>
                  <a:lnTo>
                    <a:pt x="898" y="469"/>
                  </a:lnTo>
                  <a:lnTo>
                    <a:pt x="902" y="469"/>
                  </a:lnTo>
                  <a:lnTo>
                    <a:pt x="906" y="469"/>
                  </a:lnTo>
                  <a:lnTo>
                    <a:pt x="909" y="469"/>
                  </a:lnTo>
                  <a:lnTo>
                    <a:pt x="913" y="469"/>
                  </a:lnTo>
                  <a:lnTo>
                    <a:pt x="917" y="469"/>
                  </a:lnTo>
                  <a:lnTo>
                    <a:pt x="921" y="469"/>
                  </a:lnTo>
                  <a:lnTo>
                    <a:pt x="924" y="469"/>
                  </a:lnTo>
                  <a:lnTo>
                    <a:pt x="928" y="469"/>
                  </a:lnTo>
                  <a:lnTo>
                    <a:pt x="932" y="469"/>
                  </a:lnTo>
                  <a:lnTo>
                    <a:pt x="936" y="469"/>
                  </a:lnTo>
                  <a:lnTo>
                    <a:pt x="940" y="469"/>
                  </a:lnTo>
                  <a:lnTo>
                    <a:pt x="943" y="469"/>
                  </a:lnTo>
                  <a:lnTo>
                    <a:pt x="947" y="469"/>
                  </a:lnTo>
                  <a:lnTo>
                    <a:pt x="951" y="469"/>
                  </a:lnTo>
                  <a:lnTo>
                    <a:pt x="955" y="469"/>
                  </a:lnTo>
                  <a:lnTo>
                    <a:pt x="958" y="469"/>
                  </a:lnTo>
                  <a:lnTo>
                    <a:pt x="962" y="469"/>
                  </a:lnTo>
                  <a:lnTo>
                    <a:pt x="966" y="469"/>
                  </a:lnTo>
                  <a:lnTo>
                    <a:pt x="970" y="469"/>
                  </a:lnTo>
                  <a:lnTo>
                    <a:pt x="973" y="469"/>
                  </a:lnTo>
                  <a:lnTo>
                    <a:pt x="977" y="469"/>
                  </a:lnTo>
                  <a:lnTo>
                    <a:pt x="981" y="469"/>
                  </a:lnTo>
                  <a:lnTo>
                    <a:pt x="985" y="453"/>
                  </a:lnTo>
                  <a:lnTo>
                    <a:pt x="989" y="453"/>
                  </a:lnTo>
                  <a:lnTo>
                    <a:pt x="989" y="435"/>
                  </a:lnTo>
                  <a:lnTo>
                    <a:pt x="992" y="435"/>
                  </a:lnTo>
                  <a:lnTo>
                    <a:pt x="1015" y="435"/>
                  </a:lnTo>
                  <a:lnTo>
                    <a:pt x="1015" y="420"/>
                  </a:lnTo>
                  <a:lnTo>
                    <a:pt x="1019" y="420"/>
                  </a:lnTo>
                  <a:lnTo>
                    <a:pt x="1022" y="420"/>
                  </a:lnTo>
                  <a:lnTo>
                    <a:pt x="1026" y="420"/>
                  </a:lnTo>
                  <a:lnTo>
                    <a:pt x="1030" y="420"/>
                  </a:lnTo>
                  <a:lnTo>
                    <a:pt x="1034" y="420"/>
                  </a:lnTo>
                  <a:lnTo>
                    <a:pt x="1038" y="420"/>
                  </a:lnTo>
                  <a:lnTo>
                    <a:pt x="1041" y="420"/>
                  </a:lnTo>
                  <a:lnTo>
                    <a:pt x="1045" y="420"/>
                  </a:lnTo>
                  <a:lnTo>
                    <a:pt x="1049" y="420"/>
                  </a:lnTo>
                  <a:lnTo>
                    <a:pt x="1053" y="420"/>
                  </a:lnTo>
                  <a:lnTo>
                    <a:pt x="1056" y="420"/>
                  </a:lnTo>
                  <a:lnTo>
                    <a:pt x="1060" y="420"/>
                  </a:lnTo>
                  <a:lnTo>
                    <a:pt x="1064" y="420"/>
                  </a:lnTo>
                  <a:lnTo>
                    <a:pt x="1068" y="420"/>
                  </a:lnTo>
                  <a:lnTo>
                    <a:pt x="1068" y="401"/>
                  </a:lnTo>
                  <a:lnTo>
                    <a:pt x="1071" y="401"/>
                  </a:lnTo>
                  <a:lnTo>
                    <a:pt x="1075" y="401"/>
                  </a:lnTo>
                  <a:lnTo>
                    <a:pt x="1075" y="386"/>
                  </a:lnTo>
                  <a:lnTo>
                    <a:pt x="1079" y="386"/>
                  </a:lnTo>
                  <a:lnTo>
                    <a:pt x="1083" y="386"/>
                  </a:lnTo>
                  <a:lnTo>
                    <a:pt x="1083" y="367"/>
                  </a:lnTo>
                  <a:lnTo>
                    <a:pt x="1087" y="367"/>
                  </a:lnTo>
                  <a:lnTo>
                    <a:pt x="1090" y="367"/>
                  </a:lnTo>
                  <a:lnTo>
                    <a:pt x="1094" y="367"/>
                  </a:lnTo>
                  <a:lnTo>
                    <a:pt x="1098" y="367"/>
                  </a:lnTo>
                  <a:lnTo>
                    <a:pt x="1105" y="367"/>
                  </a:lnTo>
                  <a:lnTo>
                    <a:pt x="1109" y="367"/>
                  </a:lnTo>
                  <a:lnTo>
                    <a:pt x="1113" y="367"/>
                  </a:lnTo>
                  <a:lnTo>
                    <a:pt x="1117" y="367"/>
                  </a:lnTo>
                  <a:lnTo>
                    <a:pt x="1121" y="367"/>
                  </a:lnTo>
                  <a:lnTo>
                    <a:pt x="1124" y="367"/>
                  </a:lnTo>
                  <a:lnTo>
                    <a:pt x="1128" y="367"/>
                  </a:lnTo>
                  <a:lnTo>
                    <a:pt x="1132" y="367"/>
                  </a:lnTo>
                  <a:lnTo>
                    <a:pt x="1136" y="367"/>
                  </a:lnTo>
                  <a:lnTo>
                    <a:pt x="1139" y="367"/>
                  </a:lnTo>
                  <a:lnTo>
                    <a:pt x="1143" y="367"/>
                  </a:lnTo>
                  <a:lnTo>
                    <a:pt x="1147" y="367"/>
                  </a:lnTo>
                  <a:lnTo>
                    <a:pt x="1151" y="367"/>
                  </a:lnTo>
                  <a:lnTo>
                    <a:pt x="1158" y="367"/>
                  </a:lnTo>
                  <a:lnTo>
                    <a:pt x="1162" y="367"/>
                  </a:lnTo>
                  <a:lnTo>
                    <a:pt x="1166" y="367"/>
                  </a:lnTo>
                  <a:lnTo>
                    <a:pt x="1170" y="367"/>
                  </a:lnTo>
                  <a:lnTo>
                    <a:pt x="1173" y="352"/>
                  </a:lnTo>
                  <a:lnTo>
                    <a:pt x="1177" y="352"/>
                  </a:lnTo>
                  <a:lnTo>
                    <a:pt x="1181" y="352"/>
                  </a:lnTo>
                  <a:lnTo>
                    <a:pt x="1185" y="352"/>
                  </a:lnTo>
                  <a:lnTo>
                    <a:pt x="1188" y="352"/>
                  </a:lnTo>
                  <a:lnTo>
                    <a:pt x="1192" y="352"/>
                  </a:lnTo>
                  <a:lnTo>
                    <a:pt x="1196" y="352"/>
                  </a:lnTo>
                  <a:lnTo>
                    <a:pt x="1200" y="352"/>
                  </a:lnTo>
                  <a:lnTo>
                    <a:pt x="1203" y="352"/>
                  </a:lnTo>
                  <a:lnTo>
                    <a:pt x="1211" y="352"/>
                  </a:lnTo>
                  <a:lnTo>
                    <a:pt x="1219" y="352"/>
                  </a:lnTo>
                  <a:lnTo>
                    <a:pt x="1222" y="352"/>
                  </a:lnTo>
                  <a:lnTo>
                    <a:pt x="1226" y="352"/>
                  </a:lnTo>
                  <a:lnTo>
                    <a:pt x="1230" y="352"/>
                  </a:lnTo>
                  <a:lnTo>
                    <a:pt x="1234" y="352"/>
                  </a:lnTo>
                  <a:lnTo>
                    <a:pt x="1237" y="352"/>
                  </a:lnTo>
                  <a:lnTo>
                    <a:pt x="1237" y="333"/>
                  </a:lnTo>
                  <a:lnTo>
                    <a:pt x="1245" y="333"/>
                  </a:lnTo>
                  <a:lnTo>
                    <a:pt x="1249" y="333"/>
                  </a:lnTo>
                  <a:lnTo>
                    <a:pt x="1253" y="333"/>
                  </a:lnTo>
                  <a:lnTo>
                    <a:pt x="1256" y="333"/>
                  </a:lnTo>
                  <a:lnTo>
                    <a:pt x="1260" y="333"/>
                  </a:lnTo>
                  <a:lnTo>
                    <a:pt x="1264" y="333"/>
                  </a:lnTo>
                  <a:lnTo>
                    <a:pt x="1268" y="333"/>
                  </a:lnTo>
                  <a:lnTo>
                    <a:pt x="1271" y="333"/>
                  </a:lnTo>
                  <a:lnTo>
                    <a:pt x="1275" y="333"/>
                  </a:lnTo>
                  <a:lnTo>
                    <a:pt x="1279" y="333"/>
                  </a:lnTo>
                  <a:lnTo>
                    <a:pt x="1283" y="333"/>
                  </a:lnTo>
                  <a:lnTo>
                    <a:pt x="1286" y="333"/>
                  </a:lnTo>
                  <a:lnTo>
                    <a:pt x="1290" y="333"/>
                  </a:lnTo>
                  <a:lnTo>
                    <a:pt x="1294" y="333"/>
                  </a:lnTo>
                  <a:lnTo>
                    <a:pt x="1298" y="333"/>
                  </a:lnTo>
                  <a:lnTo>
                    <a:pt x="1302" y="333"/>
                  </a:lnTo>
                  <a:lnTo>
                    <a:pt x="1305" y="333"/>
                  </a:lnTo>
                  <a:lnTo>
                    <a:pt x="1309" y="318"/>
                  </a:lnTo>
                  <a:lnTo>
                    <a:pt x="1313" y="318"/>
                  </a:lnTo>
                  <a:lnTo>
                    <a:pt x="1317" y="318"/>
                  </a:lnTo>
                  <a:lnTo>
                    <a:pt x="1320" y="318"/>
                  </a:lnTo>
                  <a:lnTo>
                    <a:pt x="1324" y="318"/>
                  </a:lnTo>
                  <a:lnTo>
                    <a:pt x="1328" y="318"/>
                  </a:lnTo>
                  <a:lnTo>
                    <a:pt x="1332" y="318"/>
                  </a:lnTo>
                  <a:lnTo>
                    <a:pt x="1335" y="318"/>
                  </a:lnTo>
                  <a:lnTo>
                    <a:pt x="1343" y="318"/>
                  </a:lnTo>
                  <a:lnTo>
                    <a:pt x="1347" y="318"/>
                  </a:lnTo>
                  <a:lnTo>
                    <a:pt x="1351" y="302"/>
                  </a:lnTo>
                  <a:lnTo>
                    <a:pt x="1354" y="302"/>
                  </a:lnTo>
                  <a:lnTo>
                    <a:pt x="1358" y="302"/>
                  </a:lnTo>
                  <a:lnTo>
                    <a:pt x="1358" y="284"/>
                  </a:lnTo>
                  <a:lnTo>
                    <a:pt x="1362" y="284"/>
                  </a:lnTo>
                  <a:lnTo>
                    <a:pt x="1366" y="284"/>
                  </a:lnTo>
                  <a:lnTo>
                    <a:pt x="1369" y="284"/>
                  </a:lnTo>
                  <a:lnTo>
                    <a:pt x="1377" y="284"/>
                  </a:lnTo>
                  <a:lnTo>
                    <a:pt x="1377" y="268"/>
                  </a:lnTo>
                  <a:lnTo>
                    <a:pt x="1381" y="268"/>
                  </a:lnTo>
                  <a:lnTo>
                    <a:pt x="1385" y="268"/>
                  </a:lnTo>
                  <a:lnTo>
                    <a:pt x="1388" y="268"/>
                  </a:lnTo>
                  <a:lnTo>
                    <a:pt x="1392" y="268"/>
                  </a:lnTo>
                  <a:lnTo>
                    <a:pt x="1392" y="253"/>
                  </a:lnTo>
                  <a:lnTo>
                    <a:pt x="1396" y="253"/>
                  </a:lnTo>
                  <a:lnTo>
                    <a:pt x="1400" y="253"/>
                  </a:lnTo>
                  <a:lnTo>
                    <a:pt x="1403" y="253"/>
                  </a:lnTo>
                  <a:lnTo>
                    <a:pt x="1407" y="253"/>
                  </a:lnTo>
                  <a:lnTo>
                    <a:pt x="1411" y="253"/>
                  </a:lnTo>
                  <a:lnTo>
                    <a:pt x="1415" y="253"/>
                  </a:lnTo>
                  <a:lnTo>
                    <a:pt x="1418" y="253"/>
                  </a:lnTo>
                  <a:lnTo>
                    <a:pt x="1422" y="253"/>
                  </a:lnTo>
                  <a:lnTo>
                    <a:pt x="1426" y="253"/>
                  </a:lnTo>
                  <a:lnTo>
                    <a:pt x="1430" y="253"/>
                  </a:lnTo>
                  <a:lnTo>
                    <a:pt x="1434" y="253"/>
                  </a:lnTo>
                  <a:lnTo>
                    <a:pt x="1437" y="253"/>
                  </a:lnTo>
                  <a:lnTo>
                    <a:pt x="1441" y="253"/>
                  </a:lnTo>
                  <a:lnTo>
                    <a:pt x="1445" y="253"/>
                  </a:lnTo>
                  <a:lnTo>
                    <a:pt x="1445" y="238"/>
                  </a:lnTo>
                  <a:lnTo>
                    <a:pt x="1449" y="238"/>
                  </a:lnTo>
                  <a:lnTo>
                    <a:pt x="1452" y="238"/>
                  </a:lnTo>
                  <a:lnTo>
                    <a:pt x="1452" y="223"/>
                  </a:lnTo>
                  <a:lnTo>
                    <a:pt x="1456" y="223"/>
                  </a:lnTo>
                  <a:lnTo>
                    <a:pt x="1460" y="223"/>
                  </a:lnTo>
                  <a:lnTo>
                    <a:pt x="1460" y="208"/>
                  </a:lnTo>
                  <a:lnTo>
                    <a:pt x="1460" y="193"/>
                  </a:lnTo>
                  <a:lnTo>
                    <a:pt x="1467" y="193"/>
                  </a:lnTo>
                  <a:lnTo>
                    <a:pt x="1467" y="178"/>
                  </a:lnTo>
                  <a:lnTo>
                    <a:pt x="1467" y="163"/>
                  </a:lnTo>
                  <a:lnTo>
                    <a:pt x="1471" y="163"/>
                  </a:lnTo>
                  <a:lnTo>
                    <a:pt x="1475" y="163"/>
                  </a:lnTo>
                  <a:lnTo>
                    <a:pt x="1479" y="163"/>
                  </a:lnTo>
                  <a:lnTo>
                    <a:pt x="1483" y="163"/>
                  </a:lnTo>
                  <a:lnTo>
                    <a:pt x="1486" y="163"/>
                  </a:lnTo>
                  <a:lnTo>
                    <a:pt x="1494" y="163"/>
                  </a:lnTo>
                  <a:lnTo>
                    <a:pt x="1498" y="163"/>
                  </a:lnTo>
                  <a:lnTo>
                    <a:pt x="1501" y="163"/>
                  </a:lnTo>
                  <a:lnTo>
                    <a:pt x="1505" y="163"/>
                  </a:lnTo>
                  <a:lnTo>
                    <a:pt x="1509" y="148"/>
                  </a:lnTo>
                  <a:lnTo>
                    <a:pt x="1513" y="148"/>
                  </a:lnTo>
                  <a:lnTo>
                    <a:pt x="1517" y="148"/>
                  </a:lnTo>
                  <a:lnTo>
                    <a:pt x="1520" y="148"/>
                  </a:lnTo>
                  <a:lnTo>
                    <a:pt x="1524" y="148"/>
                  </a:lnTo>
                  <a:lnTo>
                    <a:pt x="1532" y="148"/>
                  </a:lnTo>
                  <a:lnTo>
                    <a:pt x="1535" y="148"/>
                  </a:lnTo>
                  <a:lnTo>
                    <a:pt x="1535" y="132"/>
                  </a:lnTo>
                  <a:lnTo>
                    <a:pt x="1535" y="121"/>
                  </a:lnTo>
                  <a:lnTo>
                    <a:pt x="1539" y="121"/>
                  </a:lnTo>
                  <a:lnTo>
                    <a:pt x="1543" y="106"/>
                  </a:lnTo>
                  <a:lnTo>
                    <a:pt x="1547" y="106"/>
                  </a:lnTo>
                  <a:lnTo>
                    <a:pt x="1550" y="106"/>
                  </a:lnTo>
                  <a:lnTo>
                    <a:pt x="1554" y="106"/>
                  </a:lnTo>
                  <a:lnTo>
                    <a:pt x="1558" y="106"/>
                  </a:lnTo>
                  <a:lnTo>
                    <a:pt x="1562" y="106"/>
                  </a:lnTo>
                  <a:lnTo>
                    <a:pt x="1566" y="106"/>
                  </a:lnTo>
                  <a:lnTo>
                    <a:pt x="1569" y="106"/>
                  </a:lnTo>
                  <a:lnTo>
                    <a:pt x="1573" y="106"/>
                  </a:lnTo>
                  <a:lnTo>
                    <a:pt x="1577" y="106"/>
                  </a:lnTo>
                  <a:lnTo>
                    <a:pt x="1577" y="95"/>
                  </a:lnTo>
                  <a:lnTo>
                    <a:pt x="1581" y="95"/>
                  </a:lnTo>
                  <a:lnTo>
                    <a:pt x="1584" y="95"/>
                  </a:lnTo>
                  <a:lnTo>
                    <a:pt x="1588" y="95"/>
                  </a:lnTo>
                  <a:lnTo>
                    <a:pt x="1592" y="95"/>
                  </a:lnTo>
                  <a:lnTo>
                    <a:pt x="1596" y="95"/>
                  </a:lnTo>
                  <a:lnTo>
                    <a:pt x="1599" y="95"/>
                  </a:lnTo>
                  <a:lnTo>
                    <a:pt x="1603" y="95"/>
                  </a:lnTo>
                  <a:lnTo>
                    <a:pt x="1607" y="95"/>
                  </a:lnTo>
                  <a:lnTo>
                    <a:pt x="1611" y="80"/>
                  </a:lnTo>
                  <a:lnTo>
                    <a:pt x="1615" y="80"/>
                  </a:lnTo>
                  <a:lnTo>
                    <a:pt x="1618" y="80"/>
                  </a:lnTo>
                  <a:lnTo>
                    <a:pt x="1622" y="80"/>
                  </a:lnTo>
                  <a:lnTo>
                    <a:pt x="1626" y="80"/>
                  </a:lnTo>
                  <a:lnTo>
                    <a:pt x="1626" y="68"/>
                  </a:lnTo>
                  <a:lnTo>
                    <a:pt x="1630" y="68"/>
                  </a:lnTo>
                  <a:lnTo>
                    <a:pt x="1633" y="68"/>
                  </a:lnTo>
                  <a:lnTo>
                    <a:pt x="1637" y="68"/>
                  </a:lnTo>
                  <a:lnTo>
                    <a:pt x="1641" y="68"/>
                  </a:lnTo>
                  <a:lnTo>
                    <a:pt x="1645" y="68"/>
                  </a:lnTo>
                  <a:lnTo>
                    <a:pt x="1648" y="68"/>
                  </a:lnTo>
                  <a:lnTo>
                    <a:pt x="1656" y="68"/>
                  </a:lnTo>
                  <a:lnTo>
                    <a:pt x="1660" y="68"/>
                  </a:lnTo>
                  <a:lnTo>
                    <a:pt x="1664" y="68"/>
                  </a:lnTo>
                  <a:lnTo>
                    <a:pt x="1667" y="68"/>
                  </a:lnTo>
                  <a:lnTo>
                    <a:pt x="1671" y="68"/>
                  </a:lnTo>
                  <a:lnTo>
                    <a:pt x="1675" y="68"/>
                  </a:lnTo>
                  <a:lnTo>
                    <a:pt x="1679" y="68"/>
                  </a:lnTo>
                  <a:lnTo>
                    <a:pt x="1682" y="68"/>
                  </a:lnTo>
                  <a:lnTo>
                    <a:pt x="1686" y="68"/>
                  </a:lnTo>
                  <a:lnTo>
                    <a:pt x="1690" y="68"/>
                  </a:lnTo>
                  <a:lnTo>
                    <a:pt x="1694" y="68"/>
                  </a:lnTo>
                  <a:lnTo>
                    <a:pt x="1698" y="68"/>
                  </a:lnTo>
                  <a:lnTo>
                    <a:pt x="1701" y="68"/>
                  </a:lnTo>
                  <a:lnTo>
                    <a:pt x="1705" y="68"/>
                  </a:lnTo>
                  <a:lnTo>
                    <a:pt x="1709" y="68"/>
                  </a:lnTo>
                  <a:lnTo>
                    <a:pt x="1713" y="68"/>
                  </a:lnTo>
                  <a:lnTo>
                    <a:pt x="1713" y="57"/>
                  </a:lnTo>
                  <a:lnTo>
                    <a:pt x="1716" y="46"/>
                  </a:lnTo>
                  <a:lnTo>
                    <a:pt x="1720" y="46"/>
                  </a:lnTo>
                  <a:lnTo>
                    <a:pt x="1724" y="34"/>
                  </a:lnTo>
                  <a:lnTo>
                    <a:pt x="1728" y="34"/>
                  </a:lnTo>
                  <a:lnTo>
                    <a:pt x="1731" y="34"/>
                  </a:lnTo>
                  <a:lnTo>
                    <a:pt x="1735" y="34"/>
                  </a:lnTo>
                  <a:lnTo>
                    <a:pt x="1739" y="34"/>
                  </a:lnTo>
                  <a:lnTo>
                    <a:pt x="1743" y="34"/>
                  </a:lnTo>
                  <a:lnTo>
                    <a:pt x="1747" y="34"/>
                  </a:lnTo>
                  <a:lnTo>
                    <a:pt x="1750" y="34"/>
                  </a:lnTo>
                  <a:lnTo>
                    <a:pt x="1754" y="34"/>
                  </a:lnTo>
                  <a:lnTo>
                    <a:pt x="1758" y="34"/>
                  </a:lnTo>
                  <a:lnTo>
                    <a:pt x="1762" y="34"/>
                  </a:lnTo>
                  <a:lnTo>
                    <a:pt x="1765" y="27"/>
                  </a:lnTo>
                  <a:lnTo>
                    <a:pt x="1769" y="27"/>
                  </a:lnTo>
                  <a:lnTo>
                    <a:pt x="1769" y="19"/>
                  </a:lnTo>
                  <a:lnTo>
                    <a:pt x="1773" y="19"/>
                  </a:lnTo>
                  <a:lnTo>
                    <a:pt x="1780" y="19"/>
                  </a:lnTo>
                  <a:lnTo>
                    <a:pt x="1784" y="19"/>
                  </a:lnTo>
                  <a:lnTo>
                    <a:pt x="1788" y="19"/>
                  </a:lnTo>
                  <a:lnTo>
                    <a:pt x="1792" y="19"/>
                  </a:lnTo>
                  <a:lnTo>
                    <a:pt x="1796" y="19"/>
                  </a:lnTo>
                  <a:lnTo>
                    <a:pt x="1799" y="19"/>
                  </a:lnTo>
                  <a:lnTo>
                    <a:pt x="1803" y="19"/>
                  </a:lnTo>
                  <a:lnTo>
                    <a:pt x="1807" y="19"/>
                  </a:lnTo>
                  <a:lnTo>
                    <a:pt x="1814" y="19"/>
                  </a:lnTo>
                  <a:lnTo>
                    <a:pt x="1814" y="12"/>
                  </a:lnTo>
                  <a:lnTo>
                    <a:pt x="1818" y="12"/>
                  </a:lnTo>
                  <a:lnTo>
                    <a:pt x="1822" y="12"/>
                  </a:lnTo>
                  <a:lnTo>
                    <a:pt x="1826" y="12"/>
                  </a:lnTo>
                  <a:lnTo>
                    <a:pt x="1830" y="12"/>
                  </a:lnTo>
                  <a:lnTo>
                    <a:pt x="1837" y="12"/>
                  </a:lnTo>
                  <a:lnTo>
                    <a:pt x="1841" y="12"/>
                  </a:lnTo>
                  <a:lnTo>
                    <a:pt x="1845" y="12"/>
                  </a:lnTo>
                  <a:lnTo>
                    <a:pt x="1848" y="12"/>
                  </a:lnTo>
                  <a:lnTo>
                    <a:pt x="1852" y="12"/>
                  </a:lnTo>
                  <a:lnTo>
                    <a:pt x="1856" y="12"/>
                  </a:lnTo>
                  <a:lnTo>
                    <a:pt x="1860" y="12"/>
                  </a:lnTo>
                  <a:lnTo>
                    <a:pt x="1863" y="12"/>
                  </a:lnTo>
                  <a:lnTo>
                    <a:pt x="1867" y="12"/>
                  </a:lnTo>
                  <a:lnTo>
                    <a:pt x="1875" y="12"/>
                  </a:lnTo>
                  <a:lnTo>
                    <a:pt x="1879" y="8"/>
                  </a:lnTo>
                  <a:lnTo>
                    <a:pt x="1882" y="8"/>
                  </a:lnTo>
                  <a:lnTo>
                    <a:pt x="1886" y="8"/>
                  </a:lnTo>
                  <a:lnTo>
                    <a:pt x="1890" y="8"/>
                  </a:lnTo>
                  <a:lnTo>
                    <a:pt x="1897" y="0"/>
                  </a:lnTo>
                  <a:lnTo>
                    <a:pt x="1901" y="0"/>
                  </a:lnTo>
                  <a:lnTo>
                    <a:pt x="1905" y="0"/>
                  </a:lnTo>
                  <a:lnTo>
                    <a:pt x="1912" y="0"/>
                  </a:lnTo>
                  <a:lnTo>
                    <a:pt x="1916" y="0"/>
                  </a:lnTo>
                  <a:lnTo>
                    <a:pt x="1924" y="0"/>
                  </a:lnTo>
                </a:path>
              </a:pathLst>
            </a:custGeom>
            <a:noFill/>
            <a:ln w="38160">
              <a:solidFill>
                <a:srgbClr val="000000"/>
              </a:solidFill>
              <a:prstDash val="sysDot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929880" y="5137200"/>
              <a:ext cx="99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826200" y="4503600"/>
              <a:ext cx="198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824760" y="3873600"/>
              <a:ext cx="198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824760" y="3241800"/>
              <a:ext cx="198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828000" y="2608200"/>
              <a:ext cx="198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722520" y="1978200"/>
              <a:ext cx="298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 rot="16200000">
              <a:off x="-39960" y="3565800"/>
              <a:ext cx="12214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</a:rPr>
                <a:t>Sensitivity [%]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1118520" y="5353200"/>
              <a:ext cx="99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1693800" y="5354640"/>
              <a:ext cx="198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2324880" y="5354640"/>
              <a:ext cx="198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2959920" y="5354640"/>
              <a:ext cx="198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3591720" y="5354640"/>
              <a:ext cx="198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4173840" y="5354640"/>
              <a:ext cx="298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1923120" y="5637240"/>
              <a:ext cx="15782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00-Specificity [%]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2-08T08:09:22Z</dcterms:created>
  <dc:creator>mischakw</dc:creator>
  <dc:description/>
  <dc:language>en-US</dc:language>
  <cp:lastModifiedBy>mischakw</cp:lastModifiedBy>
  <dcterms:modified xsi:type="dcterms:W3CDTF">2013-02-08T08:24:04Z</dcterms:modified>
  <cp:revision>2</cp:revision>
  <dc:subject/>
  <dc:title>Folie 1</dc:title>
</cp:coreProperties>
</file>